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3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4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5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3"/>
  </p:sldMasterIdLst>
  <p:notesMasterIdLst>
    <p:notesMasterId r:id="rId12"/>
  </p:notesMasterIdLst>
  <p:sldIdLst>
    <p:sldId id="259" r:id="rId4"/>
    <p:sldId id="261" r:id="rId5"/>
    <p:sldId id="264" r:id="rId6"/>
    <p:sldId id="1175" r:id="rId7"/>
    <p:sldId id="1173" r:id="rId8"/>
    <p:sldId id="1177" r:id="rId9"/>
    <p:sldId id="1174" r:id="rId10"/>
    <p:sldId id="1176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D03F"/>
    <a:srgbClr val="F7DC6F"/>
    <a:srgbClr val="F9E79F"/>
    <a:srgbClr val="52BE80"/>
    <a:srgbClr val="7DCEA0"/>
    <a:srgbClr val="A9DFBF"/>
    <a:srgbClr val="EC7063"/>
    <a:srgbClr val="C4E9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2316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7" Type="http://schemas.openxmlformats.org/officeDocument/2006/relationships/slide" Target="slides/slide4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andner, Sebastian" userId="93a1434c-6d5d-440e-a0af-026354d6dfd5" providerId="ADAL" clId="{5B7986A1-833D-4879-96FD-69D84FD1D10D}"/>
    <pc:docChg chg="modSld sldOrd">
      <pc:chgData name="Brandner, Sebastian" userId="93a1434c-6d5d-440e-a0af-026354d6dfd5" providerId="ADAL" clId="{5B7986A1-833D-4879-96FD-69D84FD1D10D}" dt="2024-11-10T16:09:15.009" v="1"/>
      <pc:docMkLst>
        <pc:docMk/>
      </pc:docMkLst>
      <pc:sldChg chg="ord">
        <pc:chgData name="Brandner, Sebastian" userId="93a1434c-6d5d-440e-a0af-026354d6dfd5" providerId="ADAL" clId="{5B7986A1-833D-4879-96FD-69D84FD1D10D}" dt="2024-11-10T16:09:15.009" v="1"/>
        <pc:sldMkLst>
          <pc:docMk/>
          <pc:sldMk cId="3201894634" sldId="1173"/>
        </pc:sldMkLst>
      </pc:sldChg>
    </pc:docChg>
  </pc:docChgLst>
  <pc:docChgLst>
    <pc:chgData name="Brandner, Sebastian" userId="93a1434c-6d5d-440e-a0af-026354d6dfd5" providerId="ADAL" clId="{997904F6-14F9-47DF-ADFC-BC5E39C9088C}"/>
    <pc:docChg chg="undo custSel delSld modSld sldOrd">
      <pc:chgData name="Brandner, Sebastian" userId="93a1434c-6d5d-440e-a0af-026354d6dfd5" providerId="ADAL" clId="{997904F6-14F9-47DF-ADFC-BC5E39C9088C}" dt="2024-11-11T18:46:56.776" v="376" actId="20577"/>
      <pc:docMkLst>
        <pc:docMk/>
      </pc:docMkLst>
      <pc:sldChg chg="addSp delSp modSp mod">
        <pc:chgData name="Brandner, Sebastian" userId="93a1434c-6d5d-440e-a0af-026354d6dfd5" providerId="ADAL" clId="{997904F6-14F9-47DF-ADFC-BC5E39C9088C}" dt="2024-11-10T16:53:01.234" v="95" actId="20577"/>
        <pc:sldMkLst>
          <pc:docMk/>
          <pc:sldMk cId="109857222" sldId="256"/>
        </pc:sldMkLst>
      </pc:sldChg>
      <pc:sldChg chg="addSp delSp modSp mod">
        <pc:chgData name="Brandner, Sebastian" userId="93a1434c-6d5d-440e-a0af-026354d6dfd5" providerId="ADAL" clId="{997904F6-14F9-47DF-ADFC-BC5E39C9088C}" dt="2024-11-10T17:00:45.351" v="175" actId="1036"/>
        <pc:sldMkLst>
          <pc:docMk/>
          <pc:sldMk cId="3176086969" sldId="258"/>
        </pc:sldMkLst>
      </pc:sldChg>
      <pc:sldChg chg="del">
        <pc:chgData name="Brandner, Sebastian" userId="93a1434c-6d5d-440e-a0af-026354d6dfd5" providerId="ADAL" clId="{997904F6-14F9-47DF-ADFC-BC5E39C9088C}" dt="2024-11-11T13:28:54.601" v="256" actId="2696"/>
        <pc:sldMkLst>
          <pc:docMk/>
          <pc:sldMk cId="3888455252" sldId="260"/>
        </pc:sldMkLst>
      </pc:sldChg>
      <pc:sldChg chg="delSp del mod">
        <pc:chgData name="Brandner, Sebastian" userId="93a1434c-6d5d-440e-a0af-026354d6dfd5" providerId="ADAL" clId="{997904F6-14F9-47DF-ADFC-BC5E39C9088C}" dt="2024-11-10T17:07:39.838" v="211" actId="47"/>
        <pc:sldMkLst>
          <pc:docMk/>
          <pc:sldMk cId="2497759274" sldId="262"/>
        </pc:sldMkLst>
      </pc:sldChg>
      <pc:sldChg chg="modSp mod ord">
        <pc:chgData name="Brandner, Sebastian" userId="93a1434c-6d5d-440e-a0af-026354d6dfd5" providerId="ADAL" clId="{997904F6-14F9-47DF-ADFC-BC5E39C9088C}" dt="2024-11-10T17:01:14.082" v="179" actId="20577"/>
        <pc:sldMkLst>
          <pc:docMk/>
          <pc:sldMk cId="2307743356" sldId="263"/>
        </pc:sldMkLst>
      </pc:sldChg>
      <pc:sldChg chg="addSp delSp modSp mod">
        <pc:chgData name="Brandner, Sebastian" userId="93a1434c-6d5d-440e-a0af-026354d6dfd5" providerId="ADAL" clId="{997904F6-14F9-47DF-ADFC-BC5E39C9088C}" dt="2024-11-11T18:16:08.075" v="364" actId="20577"/>
        <pc:sldMkLst>
          <pc:docMk/>
          <pc:sldMk cId="939703778" sldId="264"/>
        </pc:sldMkLst>
      </pc:sldChg>
      <pc:sldChg chg="delSp del mod">
        <pc:chgData name="Brandner, Sebastian" userId="93a1434c-6d5d-440e-a0af-026354d6dfd5" providerId="ADAL" clId="{997904F6-14F9-47DF-ADFC-BC5E39C9088C}" dt="2024-11-10T17:07:41.945" v="212" actId="47"/>
        <pc:sldMkLst>
          <pc:docMk/>
          <pc:sldMk cId="1121778357" sldId="266"/>
        </pc:sldMkLst>
      </pc:sldChg>
      <pc:sldChg chg="delSp del mod">
        <pc:chgData name="Brandner, Sebastian" userId="93a1434c-6d5d-440e-a0af-026354d6dfd5" providerId="ADAL" clId="{997904F6-14F9-47DF-ADFC-BC5E39C9088C}" dt="2024-11-10T17:06:59.528" v="210" actId="47"/>
        <pc:sldMkLst>
          <pc:docMk/>
          <pc:sldMk cId="4248717600" sldId="1172"/>
        </pc:sldMkLst>
      </pc:sldChg>
      <pc:sldChg chg="addSp modSp mod">
        <pc:chgData name="Brandner, Sebastian" userId="93a1434c-6d5d-440e-a0af-026354d6dfd5" providerId="ADAL" clId="{997904F6-14F9-47DF-ADFC-BC5E39C9088C}" dt="2024-11-11T13:20:12.492" v="216" actId="20577"/>
        <pc:sldMkLst>
          <pc:docMk/>
          <pc:sldMk cId="3201894634" sldId="1173"/>
        </pc:sldMkLst>
      </pc:sldChg>
      <pc:sldChg chg="addSp delSp modSp mod ord">
        <pc:chgData name="Brandner, Sebastian" userId="93a1434c-6d5d-440e-a0af-026354d6dfd5" providerId="ADAL" clId="{997904F6-14F9-47DF-ADFC-BC5E39C9088C}" dt="2024-11-10T17:05:57.763" v="209" actId="20577"/>
        <pc:sldMkLst>
          <pc:docMk/>
          <pc:sldMk cId="2080962392" sldId="1175"/>
        </pc:sldMkLst>
      </pc:sldChg>
      <pc:sldChg chg="addSp delSp modSp mod">
        <pc:chgData name="Brandner, Sebastian" userId="93a1434c-6d5d-440e-a0af-026354d6dfd5" providerId="ADAL" clId="{997904F6-14F9-47DF-ADFC-BC5E39C9088C}" dt="2024-11-11T13:25:56.724" v="255" actId="404"/>
        <pc:sldMkLst>
          <pc:docMk/>
          <pc:sldMk cId="3800757996" sldId="1176"/>
        </pc:sldMkLst>
      </pc:sldChg>
      <pc:sldChg chg="modSp mod ord">
        <pc:chgData name="Brandner, Sebastian" userId="93a1434c-6d5d-440e-a0af-026354d6dfd5" providerId="ADAL" clId="{997904F6-14F9-47DF-ADFC-BC5E39C9088C}" dt="2024-11-11T18:46:56.776" v="376" actId="20577"/>
        <pc:sldMkLst>
          <pc:docMk/>
          <pc:sldMk cId="2101259563" sldId="1178"/>
        </pc:sldMkLst>
      </pc:sldChg>
    </pc:docChg>
  </pc:docChgLst>
  <pc:docChgLst>
    <pc:chgData name="Brandner, Sebastian" userId="93a1434c-6d5d-440e-a0af-026354d6dfd5" providerId="ADAL" clId="{507C318C-64D2-457D-92C4-B016BA4783D4}"/>
    <pc:docChg chg="custSel addSld modSld">
      <pc:chgData name="Brandner, Sebastian" userId="93a1434c-6d5d-440e-a0af-026354d6dfd5" providerId="ADAL" clId="{507C318C-64D2-457D-92C4-B016BA4783D4}" dt="2024-10-29T18:36:38.411" v="39" actId="14100"/>
      <pc:docMkLst>
        <pc:docMk/>
      </pc:docMkLst>
      <pc:sldChg chg="modSp mod">
        <pc:chgData name="Brandner, Sebastian" userId="93a1434c-6d5d-440e-a0af-026354d6dfd5" providerId="ADAL" clId="{507C318C-64D2-457D-92C4-B016BA4783D4}" dt="2024-10-29T18:29:58.822" v="4" actId="6549"/>
        <pc:sldMkLst>
          <pc:docMk/>
          <pc:sldMk cId="109857222" sldId="256"/>
        </pc:sldMkLst>
      </pc:sldChg>
      <pc:sldChg chg="modSp mod">
        <pc:chgData name="Brandner, Sebastian" userId="93a1434c-6d5d-440e-a0af-026354d6dfd5" providerId="ADAL" clId="{507C318C-64D2-457D-92C4-B016BA4783D4}" dt="2024-10-29T18:29:53.319" v="2" actId="20577"/>
        <pc:sldMkLst>
          <pc:docMk/>
          <pc:sldMk cId="3867077410" sldId="257"/>
        </pc:sldMkLst>
      </pc:sldChg>
      <pc:sldChg chg="modSp mod">
        <pc:chgData name="Brandner, Sebastian" userId="93a1434c-6d5d-440e-a0af-026354d6dfd5" providerId="ADAL" clId="{507C318C-64D2-457D-92C4-B016BA4783D4}" dt="2024-10-29T18:30:03.290" v="6" actId="20577"/>
        <pc:sldMkLst>
          <pc:docMk/>
          <pc:sldMk cId="3176086969" sldId="258"/>
        </pc:sldMkLst>
      </pc:sldChg>
      <pc:sldChg chg="modSp mod">
        <pc:chgData name="Brandner, Sebastian" userId="93a1434c-6d5d-440e-a0af-026354d6dfd5" providerId="ADAL" clId="{507C318C-64D2-457D-92C4-B016BA4783D4}" dt="2024-10-29T18:30:08.712" v="8" actId="20577"/>
        <pc:sldMkLst>
          <pc:docMk/>
          <pc:sldMk cId="2497759274" sldId="262"/>
        </pc:sldMkLst>
      </pc:sldChg>
      <pc:sldChg chg="modSp mod">
        <pc:chgData name="Brandner, Sebastian" userId="93a1434c-6d5d-440e-a0af-026354d6dfd5" providerId="ADAL" clId="{507C318C-64D2-457D-92C4-B016BA4783D4}" dt="2024-10-29T18:30:15.798" v="10" actId="20577"/>
        <pc:sldMkLst>
          <pc:docMk/>
          <pc:sldMk cId="2307743356" sldId="263"/>
        </pc:sldMkLst>
      </pc:sldChg>
      <pc:sldChg chg="modSp mod">
        <pc:chgData name="Brandner, Sebastian" userId="93a1434c-6d5d-440e-a0af-026354d6dfd5" providerId="ADAL" clId="{507C318C-64D2-457D-92C4-B016BA4783D4}" dt="2024-10-29T18:30:12.234" v="9" actId="20577"/>
        <pc:sldMkLst>
          <pc:docMk/>
          <pc:sldMk cId="1121778357" sldId="266"/>
        </pc:sldMkLst>
      </pc:sldChg>
      <pc:sldChg chg="delSp modSp mod">
        <pc:chgData name="Brandner, Sebastian" userId="93a1434c-6d5d-440e-a0af-026354d6dfd5" providerId="ADAL" clId="{507C318C-64D2-457D-92C4-B016BA4783D4}" dt="2024-10-29T18:30:51.463" v="17" actId="1076"/>
        <pc:sldMkLst>
          <pc:docMk/>
          <pc:sldMk cId="4248717600" sldId="1172"/>
        </pc:sldMkLst>
      </pc:sldChg>
      <pc:sldChg chg="modSp mod">
        <pc:chgData name="Brandner, Sebastian" userId="93a1434c-6d5d-440e-a0af-026354d6dfd5" providerId="ADAL" clId="{507C318C-64D2-457D-92C4-B016BA4783D4}" dt="2024-10-29T18:30:20.858" v="12" actId="20577"/>
        <pc:sldMkLst>
          <pc:docMk/>
          <pc:sldMk cId="2080962392" sldId="1175"/>
        </pc:sldMkLst>
      </pc:sldChg>
      <pc:sldChg chg="modSp mod">
        <pc:chgData name="Brandner, Sebastian" userId="93a1434c-6d5d-440e-a0af-026354d6dfd5" providerId="ADAL" clId="{507C318C-64D2-457D-92C4-B016BA4783D4}" dt="2024-10-29T18:30:26.314" v="13" actId="20577"/>
        <pc:sldMkLst>
          <pc:docMk/>
          <pc:sldMk cId="2101259563" sldId="1178"/>
        </pc:sldMkLst>
      </pc:sldChg>
      <pc:sldChg chg="addSp modSp add mod">
        <pc:chgData name="Brandner, Sebastian" userId="93a1434c-6d5d-440e-a0af-026354d6dfd5" providerId="ADAL" clId="{507C318C-64D2-457D-92C4-B016BA4783D4}" dt="2024-10-29T18:36:38.411" v="39" actId="14100"/>
        <pc:sldMkLst>
          <pc:docMk/>
          <pc:sldMk cId="3376586388" sldId="1179"/>
        </pc:sldMkLst>
      </pc:sldChg>
    </pc:docChg>
  </pc:docChgLst>
  <pc:docChgLst>
    <pc:chgData name="Brandner, Sebastian" userId="93a1434c-6d5d-440e-a0af-026354d6dfd5" providerId="ADAL" clId="{02B6CB12-A0BE-4236-8FE6-66AE77CFA237}"/>
    <pc:docChg chg="delSld">
      <pc:chgData name="Brandner, Sebastian" userId="93a1434c-6d5d-440e-a0af-026354d6dfd5" providerId="ADAL" clId="{02B6CB12-A0BE-4236-8FE6-66AE77CFA237}" dt="2024-11-17T06:08:08.921" v="0" actId="47"/>
      <pc:docMkLst>
        <pc:docMk/>
      </pc:docMkLst>
      <pc:sldChg chg="del">
        <pc:chgData name="Brandner, Sebastian" userId="93a1434c-6d5d-440e-a0af-026354d6dfd5" providerId="ADAL" clId="{02B6CB12-A0BE-4236-8FE6-66AE77CFA237}" dt="2024-11-17T06:08:08.921" v="0" actId="47"/>
        <pc:sldMkLst>
          <pc:docMk/>
          <pc:sldMk cId="109857222" sldId="256"/>
        </pc:sldMkLst>
      </pc:sldChg>
      <pc:sldChg chg="del">
        <pc:chgData name="Brandner, Sebastian" userId="93a1434c-6d5d-440e-a0af-026354d6dfd5" providerId="ADAL" clId="{02B6CB12-A0BE-4236-8FE6-66AE77CFA237}" dt="2024-11-17T06:08:08.921" v="0" actId="47"/>
        <pc:sldMkLst>
          <pc:docMk/>
          <pc:sldMk cId="3867077410" sldId="257"/>
        </pc:sldMkLst>
      </pc:sldChg>
      <pc:sldChg chg="del">
        <pc:chgData name="Brandner, Sebastian" userId="93a1434c-6d5d-440e-a0af-026354d6dfd5" providerId="ADAL" clId="{02B6CB12-A0BE-4236-8FE6-66AE77CFA237}" dt="2024-11-17T06:08:08.921" v="0" actId="47"/>
        <pc:sldMkLst>
          <pc:docMk/>
          <pc:sldMk cId="3176086969" sldId="258"/>
        </pc:sldMkLst>
      </pc:sldChg>
      <pc:sldChg chg="del">
        <pc:chgData name="Brandner, Sebastian" userId="93a1434c-6d5d-440e-a0af-026354d6dfd5" providerId="ADAL" clId="{02B6CB12-A0BE-4236-8FE6-66AE77CFA237}" dt="2024-11-17T06:08:08.921" v="0" actId="47"/>
        <pc:sldMkLst>
          <pc:docMk/>
          <pc:sldMk cId="2307743356" sldId="263"/>
        </pc:sldMkLst>
      </pc:sldChg>
      <pc:sldChg chg="del">
        <pc:chgData name="Brandner, Sebastian" userId="93a1434c-6d5d-440e-a0af-026354d6dfd5" providerId="ADAL" clId="{02B6CB12-A0BE-4236-8FE6-66AE77CFA237}" dt="2024-11-17T06:08:08.921" v="0" actId="47"/>
        <pc:sldMkLst>
          <pc:docMk/>
          <pc:sldMk cId="2101259563" sldId="1178"/>
        </pc:sldMkLst>
      </pc:sldChg>
      <pc:sldChg chg="del">
        <pc:chgData name="Brandner, Sebastian" userId="93a1434c-6d5d-440e-a0af-026354d6dfd5" providerId="ADAL" clId="{02B6CB12-A0BE-4236-8FE6-66AE77CFA237}" dt="2024-11-17T06:08:08.921" v="0" actId="47"/>
        <pc:sldMkLst>
          <pc:docMk/>
          <pc:sldMk cId="3376586388" sldId="1179"/>
        </pc:sldMkLst>
      </pc:sldChg>
    </pc:docChg>
  </pc:docChgLst>
  <pc:docChgLst>
    <pc:chgData name="Brandner, Sebastian" userId="93a1434c-6d5d-440e-a0af-026354d6dfd5" providerId="ADAL" clId="{C15D1C82-C913-4AAE-A363-2BF829B23E6C}"/>
    <pc:docChg chg="modSld">
      <pc:chgData name="Brandner, Sebastian" userId="93a1434c-6d5d-440e-a0af-026354d6dfd5" providerId="ADAL" clId="{C15D1C82-C913-4AAE-A363-2BF829B23E6C}" dt="2025-04-06T14:55:48.160" v="14" actId="20577"/>
      <pc:docMkLst>
        <pc:docMk/>
      </pc:docMkLst>
      <pc:sldChg chg="modSp mod">
        <pc:chgData name="Brandner, Sebastian" userId="93a1434c-6d5d-440e-a0af-026354d6dfd5" providerId="ADAL" clId="{C15D1C82-C913-4AAE-A363-2BF829B23E6C}" dt="2025-04-06T14:55:15.985" v="2" actId="20577"/>
        <pc:sldMkLst>
          <pc:docMk/>
          <pc:sldMk cId="2686864139" sldId="261"/>
        </pc:sldMkLst>
        <pc:spChg chg="mod">
          <ac:chgData name="Brandner, Sebastian" userId="93a1434c-6d5d-440e-a0af-026354d6dfd5" providerId="ADAL" clId="{C15D1C82-C913-4AAE-A363-2BF829B23E6C}" dt="2025-04-06T14:55:15.985" v="2" actId="20577"/>
          <ac:spMkLst>
            <pc:docMk/>
            <pc:sldMk cId="2686864139" sldId="261"/>
            <ac:spMk id="8" creationId="{22C91D6E-40BD-D80A-D5B5-93CDC2BA73C5}"/>
          </ac:spMkLst>
        </pc:spChg>
      </pc:sldChg>
      <pc:sldChg chg="modSp mod">
        <pc:chgData name="Brandner, Sebastian" userId="93a1434c-6d5d-440e-a0af-026354d6dfd5" providerId="ADAL" clId="{C15D1C82-C913-4AAE-A363-2BF829B23E6C}" dt="2025-04-06T14:55:20.814" v="4" actId="20577"/>
        <pc:sldMkLst>
          <pc:docMk/>
          <pc:sldMk cId="939703778" sldId="264"/>
        </pc:sldMkLst>
        <pc:spChg chg="mod">
          <ac:chgData name="Brandner, Sebastian" userId="93a1434c-6d5d-440e-a0af-026354d6dfd5" providerId="ADAL" clId="{C15D1C82-C913-4AAE-A363-2BF829B23E6C}" dt="2025-04-06T14:55:20.814" v="4" actId="20577"/>
          <ac:spMkLst>
            <pc:docMk/>
            <pc:sldMk cId="939703778" sldId="264"/>
            <ac:spMk id="2" creationId="{E5AB0AF1-93CE-C1ED-0544-7772FBB90B92}"/>
          </ac:spMkLst>
        </pc:spChg>
      </pc:sldChg>
      <pc:sldChg chg="modSp mod">
        <pc:chgData name="Brandner, Sebastian" userId="93a1434c-6d5d-440e-a0af-026354d6dfd5" providerId="ADAL" clId="{C15D1C82-C913-4AAE-A363-2BF829B23E6C}" dt="2025-04-06T14:55:31.508" v="8" actId="20577"/>
        <pc:sldMkLst>
          <pc:docMk/>
          <pc:sldMk cId="3201894634" sldId="1173"/>
        </pc:sldMkLst>
        <pc:spChg chg="mod">
          <ac:chgData name="Brandner, Sebastian" userId="93a1434c-6d5d-440e-a0af-026354d6dfd5" providerId="ADAL" clId="{C15D1C82-C913-4AAE-A363-2BF829B23E6C}" dt="2025-04-06T14:55:31.508" v="8" actId="20577"/>
          <ac:spMkLst>
            <pc:docMk/>
            <pc:sldMk cId="3201894634" sldId="1173"/>
            <ac:spMk id="8" creationId="{6ECEE427-7E6E-2BE8-FE77-DFE97D351ACA}"/>
          </ac:spMkLst>
        </pc:spChg>
      </pc:sldChg>
      <pc:sldChg chg="modSp mod">
        <pc:chgData name="Brandner, Sebastian" userId="93a1434c-6d5d-440e-a0af-026354d6dfd5" providerId="ADAL" clId="{C15D1C82-C913-4AAE-A363-2BF829B23E6C}" dt="2025-04-06T14:55:43.125" v="12" actId="20577"/>
        <pc:sldMkLst>
          <pc:docMk/>
          <pc:sldMk cId="1881372159" sldId="1174"/>
        </pc:sldMkLst>
        <pc:spChg chg="mod">
          <ac:chgData name="Brandner, Sebastian" userId="93a1434c-6d5d-440e-a0af-026354d6dfd5" providerId="ADAL" clId="{C15D1C82-C913-4AAE-A363-2BF829B23E6C}" dt="2025-04-06T14:55:43.125" v="12" actId="20577"/>
          <ac:spMkLst>
            <pc:docMk/>
            <pc:sldMk cId="1881372159" sldId="1174"/>
            <ac:spMk id="13" creationId="{A2719480-8DDE-D832-5181-4750DB4B1957}"/>
          </ac:spMkLst>
        </pc:spChg>
      </pc:sldChg>
      <pc:sldChg chg="modSp mod">
        <pc:chgData name="Brandner, Sebastian" userId="93a1434c-6d5d-440e-a0af-026354d6dfd5" providerId="ADAL" clId="{C15D1C82-C913-4AAE-A363-2BF829B23E6C}" dt="2025-04-06T14:55:26.283" v="6" actId="20577"/>
        <pc:sldMkLst>
          <pc:docMk/>
          <pc:sldMk cId="2080962392" sldId="1175"/>
        </pc:sldMkLst>
        <pc:spChg chg="mod">
          <ac:chgData name="Brandner, Sebastian" userId="93a1434c-6d5d-440e-a0af-026354d6dfd5" providerId="ADAL" clId="{C15D1C82-C913-4AAE-A363-2BF829B23E6C}" dt="2025-04-06T14:55:26.283" v="6" actId="20577"/>
          <ac:spMkLst>
            <pc:docMk/>
            <pc:sldMk cId="2080962392" sldId="1175"/>
            <ac:spMk id="4" creationId="{69C4D592-5B19-1652-F4E8-ED28ACBE693D}"/>
          </ac:spMkLst>
        </pc:spChg>
      </pc:sldChg>
      <pc:sldChg chg="modSp mod">
        <pc:chgData name="Brandner, Sebastian" userId="93a1434c-6d5d-440e-a0af-026354d6dfd5" providerId="ADAL" clId="{C15D1C82-C913-4AAE-A363-2BF829B23E6C}" dt="2025-04-06T14:55:48.160" v="14" actId="20577"/>
        <pc:sldMkLst>
          <pc:docMk/>
          <pc:sldMk cId="3800757996" sldId="1176"/>
        </pc:sldMkLst>
        <pc:spChg chg="mod">
          <ac:chgData name="Brandner, Sebastian" userId="93a1434c-6d5d-440e-a0af-026354d6dfd5" providerId="ADAL" clId="{C15D1C82-C913-4AAE-A363-2BF829B23E6C}" dt="2025-04-06T14:55:48.160" v="14" actId="20577"/>
          <ac:spMkLst>
            <pc:docMk/>
            <pc:sldMk cId="3800757996" sldId="1176"/>
            <ac:spMk id="4" creationId="{455652A2-43C2-A324-28ED-94C40D19EDF4}"/>
          </ac:spMkLst>
        </pc:spChg>
        <pc:spChg chg="mod">
          <ac:chgData name="Brandner, Sebastian" userId="93a1434c-6d5d-440e-a0af-026354d6dfd5" providerId="ADAL" clId="{C15D1C82-C913-4AAE-A363-2BF829B23E6C}" dt="2025-04-06T14:37:19.619" v="0" actId="20577"/>
          <ac:spMkLst>
            <pc:docMk/>
            <pc:sldMk cId="3800757996" sldId="1176"/>
            <ac:spMk id="8" creationId="{A698FC5E-E49B-181B-0349-34527AB6AC90}"/>
          </ac:spMkLst>
        </pc:spChg>
      </pc:sldChg>
      <pc:sldChg chg="modSp mod">
        <pc:chgData name="Brandner, Sebastian" userId="93a1434c-6d5d-440e-a0af-026354d6dfd5" providerId="ADAL" clId="{C15D1C82-C913-4AAE-A363-2BF829B23E6C}" dt="2025-04-06T14:55:38.579" v="10" actId="20577"/>
        <pc:sldMkLst>
          <pc:docMk/>
          <pc:sldMk cId="2673847740" sldId="1177"/>
        </pc:sldMkLst>
        <pc:spChg chg="mod">
          <ac:chgData name="Brandner, Sebastian" userId="93a1434c-6d5d-440e-a0af-026354d6dfd5" providerId="ADAL" clId="{C15D1C82-C913-4AAE-A363-2BF829B23E6C}" dt="2025-04-06T14:55:38.579" v="10" actId="20577"/>
          <ac:spMkLst>
            <pc:docMk/>
            <pc:sldMk cId="2673847740" sldId="1177"/>
            <ac:spMk id="13" creationId="{A2719480-8DDE-D832-5181-4750DB4B1957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5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5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nhs.sharepoint.com/sites/msteams_aaf267-NPTextbooksandLiterature/Shared%20Documents/NP%20Literature%20and%20Research/2_Research/Publications%20&amp;%20Projects/Project%20-%20Meningioma%20Methylome%20%5bBRANDNER-RUIZ%5d/Main%20Dataset/Meningioma%20Project%20Data%20Analysis%20v2.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Meningioma Project Data Analysis v2.1.xlsx]PIVOT4.0_ALL_EXT!PivotTable2</c:name>
    <c:fmtId val="-1"/>
  </c:pivotSource>
  <c:chart>
    <c:autoTitleDeleted val="0"/>
    <c:pivotFmts>
      <c:pivotFmt>
        <c:idx val="0"/>
        <c:spPr>
          <a:solidFill>
            <a:srgbClr val="92D05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rgbClr val="FFC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rgbClr val="C00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3.625196584276133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4.5032238942234654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2.9891303400303569E-2"/>
              <c:y val="-6.8789853429790814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3.6531310429484806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2.8771329187485289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3.7065346697254892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3.9018908596985764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7692801E-78FB-41A3-99FF-F1337E25CC21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18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EC1A7265-3639-4E32-8F9A-8124FD275154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19"/>
        <c:spPr>
          <a:solidFill>
            <a:srgbClr val="92D05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0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1"/>
        <c:spPr>
          <a:solidFill>
            <a:srgbClr val="FFC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2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3"/>
        <c:spPr>
          <a:solidFill>
            <a:srgbClr val="C00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4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3.625196584276133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5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7692801E-78FB-41A3-99FF-F1337E25CC21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26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EC1A7265-3639-4E32-8F9A-8124FD275154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27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8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2.8771329187485289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9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3.7065346697254892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0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8214200750107995E-2"/>
              <c:y val="6.9051305263837248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1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2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6.0085573384262785E-2"/>
              <c:y val="-3.0131826741996232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3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2.3772385844346919E-3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4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4.5032238942234654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5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6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-4.7260522908949297E-2"/>
              <c:y val="-1.6949152542372881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7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6.1701238242239283E-2"/>
              <c:y val="-1.3182674199623353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8"/>
        <c:spPr>
          <a:solidFill>
            <a:srgbClr val="FFC000"/>
          </a:solidFill>
          <a:ln>
            <a:noFill/>
          </a:ln>
          <a:effectLst/>
        </c:spPr>
        <c:dLbl>
          <c:idx val="0"/>
          <c:layout>
            <c:manualLayout>
              <c:x val="-5.119889981802838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9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6.3014030545265651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0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5.1198899818028429E-2"/>
              <c:y val="3.766478342749529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1"/>
        <c:spPr>
          <a:solidFill>
            <a:srgbClr val="FFC000"/>
          </a:solidFill>
          <a:ln>
            <a:noFill/>
          </a:ln>
          <a:effectLst/>
        </c:spPr>
        <c:dLbl>
          <c:idx val="0"/>
          <c:layout>
            <c:manualLayout>
              <c:x val="5.2511692121054748E-2"/>
              <c:y val="2.0715630885122273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2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dLbl>
          <c:idx val="0"/>
          <c:layout>
            <c:manualLayout>
              <c:x val="5.1231182651112851E-2"/>
              <c:y val="-5.6497175141242938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3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7290322447181093E-2"/>
              <c:y val="1.1299435028248518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4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5976702379203843E-2"/>
              <c:y val="1.8832391713747474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5"/>
        <c:spPr>
          <a:solidFill>
            <a:srgbClr val="92D05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6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7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6.3014030545265651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8"/>
        <c:spPr>
          <a:solidFill>
            <a:srgbClr val="FFC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9"/>
        <c:spPr>
          <a:solidFill>
            <a:srgbClr val="FFC000"/>
          </a:solidFill>
          <a:ln>
            <a:noFill/>
          </a:ln>
          <a:effectLst/>
        </c:spPr>
        <c:dLbl>
          <c:idx val="0"/>
          <c:layout>
            <c:manualLayout>
              <c:x val="-5.119889981802838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0"/>
        <c:spPr>
          <a:solidFill>
            <a:srgbClr val="FFC000"/>
          </a:solidFill>
          <a:ln>
            <a:noFill/>
          </a:ln>
          <a:effectLst/>
        </c:spPr>
        <c:dLbl>
          <c:idx val="0"/>
          <c:layout>
            <c:manualLayout>
              <c:x val="5.2511692121054748E-2"/>
              <c:y val="2.0715630885122273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1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2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6.1701238242239283E-2"/>
              <c:y val="-1.3182674199623353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3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7290322447181093E-2"/>
              <c:y val="1.1299435028248518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4"/>
        <c:spPr>
          <a:solidFill>
            <a:srgbClr val="C00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5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-4.7260522908949297E-2"/>
              <c:y val="-1.6949152542372881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6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5.1198899818028429E-2"/>
              <c:y val="3.766478342749529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7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3.625196584276133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8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7692801E-78FB-41A3-99FF-F1337E25CC21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59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EC1A7265-3639-4E32-8F9A-8124FD275154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60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1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2.8771329187485289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2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3.7065346697254892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3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8214200750107995E-2"/>
              <c:y val="6.9051305263837248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4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5976702379203843E-2"/>
              <c:y val="1.8832391713747474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5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6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6.0085573384262785E-2"/>
              <c:y val="-3.0131826741996232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7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2.3772385844346919E-3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8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4.5032238942234654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9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0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dLbl>
          <c:idx val="0"/>
          <c:layout>
            <c:manualLayout>
              <c:x val="5.1231182651112851E-2"/>
              <c:y val="-5.6497175141242938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1"/>
        <c:spPr>
          <a:solidFill>
            <a:srgbClr val="92D05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2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3"/>
        <c:spPr>
          <a:solidFill>
            <a:srgbClr val="9BBB59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6.3014030545265651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4"/>
        <c:spPr>
          <a:solidFill>
            <a:srgbClr val="FFC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5"/>
        <c:spPr>
          <a:solidFill>
            <a:srgbClr val="FFC000"/>
          </a:solidFill>
          <a:ln>
            <a:noFill/>
          </a:ln>
          <a:effectLst/>
        </c:spPr>
        <c:dLbl>
          <c:idx val="0"/>
          <c:layout>
            <c:manualLayout>
              <c:x val="-5.119889981802838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6"/>
        <c:spPr>
          <a:solidFill>
            <a:srgbClr val="FFC000"/>
          </a:solidFill>
          <a:ln>
            <a:noFill/>
          </a:ln>
          <a:effectLst/>
        </c:spPr>
        <c:dLbl>
          <c:idx val="0"/>
          <c:layout>
            <c:manualLayout>
              <c:x val="5.2511692121054748E-2"/>
              <c:y val="2.0715630885122273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7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8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6.1701238242239283E-2"/>
              <c:y val="-1.3182674199623353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9"/>
        <c:spPr>
          <a:solidFill>
            <a:srgbClr val="F79646">
              <a:lumMod val="40000"/>
              <a:lumOff val="6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7290322447181093E-2"/>
              <c:y val="1.1299435028248518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0"/>
        <c:spPr>
          <a:solidFill>
            <a:srgbClr val="C00000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1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-4.7260522908949297E-2"/>
              <c:y val="-1.6949152542372881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2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5.1198899818028429E-2"/>
              <c:y val="3.766478342749529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3"/>
        <c:spPr>
          <a:solidFill>
            <a:srgbClr val="C00000"/>
          </a:solidFill>
          <a:ln>
            <a:noFill/>
          </a:ln>
          <a:effectLst/>
        </c:spPr>
        <c:dLbl>
          <c:idx val="0"/>
          <c:layout>
            <c:manualLayout>
              <c:x val="3.625196584276133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4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7692801E-78FB-41A3-99FF-F1337E25CC21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85"/>
        <c:spPr>
          <a:solidFill>
            <a:srgbClr val="C00000"/>
          </a:solidFill>
          <a:ln>
            <a:noFill/>
          </a:ln>
          <a:effectLst/>
        </c:spPr>
        <c:dLbl>
          <c:idx val="0"/>
          <c:tx>
            <c:rich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fld id="{EC1A7265-3639-4E32-8F9A-8124FD275154}" type="VALUE">
                  <a:rPr lang="en-US">
                    <a:solidFill>
                      <a:schemeClr val="bg1"/>
                    </a:solidFill>
                  </a:rPr>
                  <a:pPr>
                    <a:defRPr sz="11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t>[VALUE]</a:t>
                </a:fld>
                <a:endParaRPr lang="en-GB"/>
              </a:p>
            </c:rich>
          </c:tx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>
              <c15:dlblFieldTable/>
              <c15:showDataLabelsRange val="0"/>
            </c:ext>
          </c:extLst>
        </c:dLbl>
      </c:pivotFmt>
      <c:pivotFmt>
        <c:idx val="86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7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2.8771329187485289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8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3.7065346697254892E-2"/>
              <c:y val="-6.8655399282359373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9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8214200750107995E-2"/>
              <c:y val="6.9051305263837248E-17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0"/>
        <c:spPr>
          <a:solidFill>
            <a:srgbClr val="C0504D">
              <a:lumMod val="60000"/>
              <a:lumOff val="40000"/>
            </a:srgbClr>
          </a:solidFill>
          <a:ln>
            <a:noFill/>
          </a:ln>
          <a:effectLst/>
        </c:spPr>
        <c:dLbl>
          <c:idx val="0"/>
          <c:layout>
            <c:manualLayout>
              <c:x val="4.5976702379203843E-2"/>
              <c:y val="1.8832391713747474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1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2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6.0085573384262785E-2"/>
              <c:y val="-3.0131826741996232E-2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3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2.3772385844346919E-3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4"/>
        <c:spPr>
          <a:solidFill>
            <a:sysClr val="window" lastClr="FFFFFF">
              <a:lumMod val="65000"/>
            </a:sysClr>
          </a:solidFill>
          <a:ln>
            <a:noFill/>
          </a:ln>
          <a:effectLst/>
        </c:spPr>
        <c:dLbl>
          <c:idx val="0"/>
          <c:layout>
            <c:manualLayout>
              <c:x val="4.5032238942234654E-2"/>
              <c:y val="0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5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6"/>
        <c:spPr>
          <a:solidFill>
            <a:sysClr val="window" lastClr="FFFFFF">
              <a:lumMod val="85000"/>
            </a:sysClr>
          </a:solidFill>
          <a:ln>
            <a:noFill/>
          </a:ln>
          <a:effectLst/>
        </c:spPr>
        <c:dLbl>
          <c:idx val="0"/>
          <c:layout>
            <c:manualLayout>
              <c:x val="5.1231182651112851E-2"/>
              <c:y val="-5.6497175141242938E-3"/>
            </c:manualLayout>
          </c:layout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>
        <c:manualLayout>
          <c:layoutTarget val="inner"/>
          <c:xMode val="edge"/>
          <c:yMode val="edge"/>
          <c:x val="4.5012600516568892E-2"/>
          <c:y val="2.7806100508622863E-2"/>
          <c:w val="0.89431012945114008"/>
          <c:h val="0.9040455536278304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PIVOT4.0_ALL_EXT!$B$3:$B$4</c:f>
              <c:strCache>
                <c:ptCount val="1"/>
                <c:pt idx="0">
                  <c:v>Meningioma CNS WHO Grade 1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B$5:$B$12</c:f>
              <c:numCache>
                <c:formatCode>General</c:formatCode>
                <c:ptCount val="7"/>
                <c:pt idx="1">
                  <c:v>1</c:v>
                </c:pt>
                <c:pt idx="2">
                  <c:v>14</c:v>
                </c:pt>
                <c:pt idx="3">
                  <c:v>28</c:v>
                </c:pt>
                <c:pt idx="4">
                  <c:v>39</c:v>
                </c:pt>
                <c:pt idx="5">
                  <c:v>71</c:v>
                </c:pt>
                <c:pt idx="6">
                  <c:v>1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A6-4A33-9863-DC3B4AAC4C45}"/>
            </c:ext>
          </c:extLst>
        </c:ser>
        <c:ser>
          <c:idx val="1"/>
          <c:order val="1"/>
          <c:tx>
            <c:strRef>
              <c:f>PIVOT4.0_ALL_EXT!$C$3:$C$4</c:f>
              <c:strCache>
                <c:ptCount val="1"/>
                <c:pt idx="0">
                  <c:v>NoArray_Meningioma CNS WHO Grade 1</c:v>
                </c:pt>
              </c:strCache>
            </c:strRef>
          </c:tx>
          <c:spPr>
            <a:solidFill>
              <a:srgbClr val="9BBB59">
                <a:lumMod val="40000"/>
                <a:lumOff val="60000"/>
              </a:srgbClr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6.3014030545265651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C$5:$C$12</c:f>
              <c:numCache>
                <c:formatCode>General</c:formatCode>
                <c:ptCount val="7"/>
                <c:pt idx="0">
                  <c:v>2</c:v>
                </c:pt>
                <c:pt idx="1">
                  <c:v>4</c:v>
                </c:pt>
                <c:pt idx="2">
                  <c:v>3</c:v>
                </c:pt>
                <c:pt idx="5">
                  <c:v>1</c:v>
                </c:pt>
                <c:pt idx="6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4A6-4A33-9863-DC3B4AAC4C45}"/>
            </c:ext>
          </c:extLst>
        </c:ser>
        <c:ser>
          <c:idx val="2"/>
          <c:order val="2"/>
          <c:tx>
            <c:strRef>
              <c:f>PIVOT4.0_ALL_EXT!$D$3:$D$4</c:f>
              <c:strCache>
                <c:ptCount val="1"/>
                <c:pt idx="0">
                  <c:v>Meningioma CNS WHO Grade 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-5.119889981802838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4A6-4A33-9863-DC3B4AAC4C45}"/>
                </c:ext>
              </c:extLst>
            </c:dLbl>
            <c:dLbl>
              <c:idx val="2"/>
              <c:layout>
                <c:manualLayout>
                  <c:x val="5.2511692121054748E-2"/>
                  <c:y val="2.071563088512227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D$5:$D$12</c:f>
              <c:numCache>
                <c:formatCode>General</c:formatCode>
                <c:ptCount val="7"/>
                <c:pt idx="1">
                  <c:v>1</c:v>
                </c:pt>
                <c:pt idx="2">
                  <c:v>5</c:v>
                </c:pt>
                <c:pt idx="3">
                  <c:v>10</c:v>
                </c:pt>
                <c:pt idx="4">
                  <c:v>24</c:v>
                </c:pt>
                <c:pt idx="5">
                  <c:v>74</c:v>
                </c:pt>
                <c:pt idx="6">
                  <c:v>1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4A6-4A33-9863-DC3B4AAC4C45}"/>
            </c:ext>
          </c:extLst>
        </c:ser>
        <c:ser>
          <c:idx val="3"/>
          <c:order val="3"/>
          <c:tx>
            <c:strRef>
              <c:f>PIVOT4.0_ALL_EXT!$E$3:$E$4</c:f>
              <c:strCache>
                <c:ptCount val="1"/>
                <c:pt idx="0">
                  <c:v>NoArray_Meningioma CNS WHO Grade 2</c:v>
                </c:pt>
              </c:strCache>
            </c:strRef>
          </c:tx>
          <c:spPr>
            <a:solidFill>
              <a:srgbClr val="F79646">
                <a:lumMod val="40000"/>
                <a:lumOff val="60000"/>
              </a:srgbClr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6.1701238242239283E-2"/>
                  <c:y val="-1.318267419962335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E4A6-4A33-9863-DC3B4AAC4C45}"/>
                </c:ext>
              </c:extLst>
            </c:dLbl>
            <c:dLbl>
              <c:idx val="5"/>
              <c:layout>
                <c:manualLayout>
                  <c:x val="4.7290322447181093E-2"/>
                  <c:y val="1.129943502824851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E$5:$E$12</c:f>
              <c:numCache>
                <c:formatCode>General</c:formatCode>
                <c:ptCount val="7"/>
                <c:pt idx="1">
                  <c:v>1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4A6-4A33-9863-DC3B4AAC4C45}"/>
            </c:ext>
          </c:extLst>
        </c:ser>
        <c:ser>
          <c:idx val="4"/>
          <c:order val="4"/>
          <c:tx>
            <c:strRef>
              <c:f>PIVOT4.0_ALL_EXT!$F$3:$F$4</c:f>
              <c:strCache>
                <c:ptCount val="1"/>
                <c:pt idx="0">
                  <c:v>Meningioma CNS WHO Grade 3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-4.7260522908949297E-2"/>
                  <c:y val="-1.694915254237288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E4A6-4A33-9863-DC3B4AAC4C45}"/>
                </c:ext>
              </c:extLst>
            </c:dLbl>
            <c:dLbl>
              <c:idx val="2"/>
              <c:layout>
                <c:manualLayout>
                  <c:x val="5.1198899818028429E-2"/>
                  <c:y val="3.76647834274952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E4A6-4A33-9863-DC3B4AAC4C45}"/>
                </c:ext>
              </c:extLst>
            </c:dLbl>
            <c:dLbl>
              <c:idx val="4"/>
              <c:layout>
                <c:manualLayout>
                  <c:x val="3.625196584276133E-2"/>
                  <c:y val="-6.8655399282359373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E4A6-4A33-9863-DC3B4AAC4C45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7692801E-78FB-41A3-99FF-F1337E25CC21}" type="VALUE">
                      <a:rPr lang="en-US">
                        <a:solidFill>
                          <a:schemeClr val="bg1"/>
                        </a:solidFill>
                      </a:rPr>
                      <a:pPr/>
                      <a:t>[VALUE]</a:t>
                    </a:fld>
                    <a:endParaRPr lang="en-GB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C-E4A6-4A33-9863-DC3B4AAC4C45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EC1A7265-3639-4E32-8F9A-8124FD275154}" type="VALUE">
                      <a:rPr lang="en-US">
                        <a:solidFill>
                          <a:schemeClr val="bg1"/>
                        </a:solidFill>
                      </a:rPr>
                      <a:pPr/>
                      <a:t>[VALUE]</a:t>
                    </a:fld>
                    <a:endParaRPr lang="en-GB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F$5:$F$12</c:f>
              <c:numCache>
                <c:formatCode>General</c:formatCode>
                <c:ptCount val="7"/>
                <c:pt idx="1">
                  <c:v>1</c:v>
                </c:pt>
                <c:pt idx="2">
                  <c:v>2</c:v>
                </c:pt>
                <c:pt idx="4">
                  <c:v>3</c:v>
                </c:pt>
                <c:pt idx="5">
                  <c:v>13</c:v>
                </c:pt>
                <c:pt idx="6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E4A6-4A33-9863-DC3B4AAC4C45}"/>
            </c:ext>
          </c:extLst>
        </c:ser>
        <c:ser>
          <c:idx val="5"/>
          <c:order val="5"/>
          <c:tx>
            <c:strRef>
              <c:f>PIVOT4.0_ALL_EXT!$G$3:$G$4</c:f>
              <c:strCache>
                <c:ptCount val="1"/>
                <c:pt idx="0">
                  <c:v>NoArray_Meningioma CNS WHO Grade 3</c:v>
                </c:pt>
              </c:strCache>
            </c:strRef>
          </c:tx>
          <c:spPr>
            <a:solidFill>
              <a:srgbClr val="C0504D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dLbls>
            <c:dLbl>
              <c:idx val="2"/>
              <c:layout>
                <c:manualLayout>
                  <c:x val="2.8771329187485289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E4A6-4A33-9863-DC3B4AAC4C45}"/>
                </c:ext>
              </c:extLst>
            </c:dLbl>
            <c:dLbl>
              <c:idx val="3"/>
              <c:layout>
                <c:manualLayout>
                  <c:x val="3.7065346697254892E-2"/>
                  <c:y val="-6.8655399282359373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E4A6-4A33-9863-DC3B4AAC4C45}"/>
                </c:ext>
              </c:extLst>
            </c:dLbl>
            <c:dLbl>
              <c:idx val="5"/>
              <c:layout>
                <c:manualLayout>
                  <c:x val="4.8214200750107995E-2"/>
                  <c:y val="6.9051305263837248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E4A6-4A33-9863-DC3B4AAC4C45}"/>
                </c:ext>
              </c:extLst>
            </c:dLbl>
            <c:dLbl>
              <c:idx val="6"/>
              <c:layout>
                <c:manualLayout>
                  <c:x val="4.5976702379203843E-2"/>
                  <c:y val="1.8832391713747474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2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G$5:$G$12</c:f>
              <c:numCache>
                <c:formatCode>General</c:formatCode>
                <c:ptCount val="7"/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E4A6-4A33-9863-DC3B4AAC4C45}"/>
            </c:ext>
          </c:extLst>
        </c:ser>
        <c:ser>
          <c:idx val="6"/>
          <c:order val="6"/>
          <c:tx>
            <c:strRef>
              <c:f>PIVOT4.0_ALL_EXT!$H$3:$H$4</c:f>
              <c:strCache>
                <c:ptCount val="1"/>
                <c:pt idx="0">
                  <c:v>Meningioma, Ungraded</c:v>
                </c:pt>
              </c:strCache>
            </c:strRef>
          </c:tx>
          <c:spPr>
            <a:solidFill>
              <a:sysClr val="window" lastClr="FFFFFF">
                <a:lumMod val="65000"/>
              </a:sysClr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6.0085573384262785E-2"/>
                  <c:y val="-3.013182674199623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4-E4A6-4A33-9863-DC3B4AAC4C45}"/>
                </c:ext>
              </c:extLst>
            </c:dLbl>
            <c:dLbl>
              <c:idx val="2"/>
              <c:layout>
                <c:manualLayout>
                  <c:x val="2.3772385844346919E-3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E4A6-4A33-9863-DC3B4AAC4C45}"/>
                </c:ext>
              </c:extLst>
            </c:dLbl>
            <c:dLbl>
              <c:idx val="3"/>
              <c:layout>
                <c:manualLayout>
                  <c:x val="4.5032238942234654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H$5:$H$12</c:f>
              <c:numCache>
                <c:formatCode>General</c:formatCode>
                <c:ptCount val="7"/>
                <c:pt idx="1">
                  <c:v>2</c:v>
                </c:pt>
                <c:pt idx="2">
                  <c:v>12</c:v>
                </c:pt>
                <c:pt idx="3">
                  <c:v>10</c:v>
                </c:pt>
                <c:pt idx="4">
                  <c:v>24</c:v>
                </c:pt>
                <c:pt idx="5">
                  <c:v>3</c:v>
                </c:pt>
                <c:pt idx="6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E4A6-4A33-9863-DC3B4AAC4C45}"/>
            </c:ext>
          </c:extLst>
        </c:ser>
        <c:ser>
          <c:idx val="7"/>
          <c:order val="7"/>
          <c:tx>
            <c:strRef>
              <c:f>PIVOT4.0_ALL_EXT!$I$3:$I$4</c:f>
              <c:strCache>
                <c:ptCount val="1"/>
                <c:pt idx="0">
                  <c:v>NoArray_Meningioma Ungraded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noFill/>
            </a:ln>
            <a:effectLst/>
          </c:spPr>
          <c:invertIfNegative val="0"/>
          <c:dLbls>
            <c:dLbl>
              <c:idx val="2"/>
              <c:layout>
                <c:manualLayout>
                  <c:x val="5.1231182651112851E-2"/>
                  <c:y val="-5.6497175141242938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8-E4A6-4A33-9863-DC3B4AAC4C4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PIVOT4.0_ALL_EXT!$A$5:$A$12</c:f>
              <c:strCache>
                <c:ptCount val="7"/>
                <c:pt idx="0">
                  <c:v>2017</c:v>
                </c:pt>
                <c:pt idx="1">
                  <c:v>2018</c:v>
                </c:pt>
                <c:pt idx="2">
                  <c:v>2019</c:v>
                </c:pt>
                <c:pt idx="3">
                  <c:v>2020</c:v>
                </c:pt>
                <c:pt idx="4">
                  <c:v>2021</c:v>
                </c:pt>
                <c:pt idx="5">
                  <c:v>2022</c:v>
                </c:pt>
                <c:pt idx="6">
                  <c:v>2023</c:v>
                </c:pt>
              </c:strCache>
            </c:strRef>
          </c:cat>
          <c:val>
            <c:numRef>
              <c:f>PIVOT4.0_ALL_EXT!$I$5:$I$12</c:f>
              <c:numCache>
                <c:formatCode>General</c:formatCode>
                <c:ptCount val="7"/>
                <c:pt idx="2">
                  <c:v>1</c:v>
                </c:pt>
                <c:pt idx="4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E4A6-4A33-9863-DC3B4AAC4C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398714432"/>
        <c:axId val="398714912"/>
      </c:barChart>
      <c:catAx>
        <c:axId val="398714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8714912"/>
        <c:crosses val="autoZero"/>
        <c:auto val="1"/>
        <c:lblAlgn val="ctr"/>
        <c:lblOffset val="100"/>
        <c:noMultiLvlLbl val="0"/>
      </c:catAx>
      <c:valAx>
        <c:axId val="398714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8714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4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5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6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7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7.0288603363281119E-2"/>
          <c:y val="0.13406201343476135"/>
          <c:w val="0.37767367284219056"/>
          <c:h val="0.29070688197873568"/>
        </c:manualLayout>
      </c:layout>
      <c:overlay val="0"/>
      <c:spPr>
        <a:solidFill>
          <a:sysClr val="window" lastClr="FFFFFF">
            <a:lumMod val="95000"/>
          </a:sys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en-US"/>
    </a:p>
  </c:txPr>
  <c:externalData r:id="rId4">
    <c:autoUpdate val="0"/>
  </c:externalData>
  <c:userShapes r:id="rId5"/>
  <c:extLst>
    <c:ext xmlns:c14="http://schemas.microsoft.com/office/drawing/2007/8/2/chart" uri="{781A3756-C4B2-4CAC-9D66-4F8BD8637D16}">
      <c14:pivotOptions>
        <c14:dropZoneCategories val="1"/>
        <c14:dropZoneData val="1"/>
        <c14:dropZoneSeries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v>22q intact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0"/>
              <c:pt idx="0">
                <c:v>0</c:v>
              </c:pt>
              <c:pt idx="1">
                <c:v>1</c:v>
              </c:pt>
              <c:pt idx="2">
                <c:v>2</c:v>
              </c:pt>
              <c:pt idx="3">
                <c:v>3</c:v>
              </c:pt>
              <c:pt idx="4">
                <c:v>4</c:v>
              </c:pt>
              <c:pt idx="5">
                <c:v>5</c:v>
              </c:pt>
              <c:pt idx="6">
                <c:v>6</c:v>
              </c:pt>
              <c:pt idx="7">
                <c:v>7</c:v>
              </c:pt>
              <c:pt idx="8">
                <c:v>8</c:v>
              </c:pt>
              <c:pt idx="9">
                <c:v>9</c:v>
              </c:pt>
            </c:numLit>
          </c:cat>
          <c:val>
            <c:numLit>
              <c:formatCode>General</c:formatCode>
              <c:ptCount val="10"/>
              <c:pt idx="0">
                <c:v>186</c:v>
              </c:pt>
              <c:pt idx="1">
                <c:v>97</c:v>
              </c:pt>
              <c:pt idx="2">
                <c:v>56</c:v>
              </c:pt>
              <c:pt idx="3">
                <c:v>36</c:v>
              </c:pt>
              <c:pt idx="4">
                <c:v>9</c:v>
              </c:pt>
              <c:pt idx="5">
                <c:v>4</c:v>
              </c:pt>
              <c:pt idx="6">
                <c:v>2</c:v>
              </c:pt>
            </c:numLit>
          </c:val>
          <c:extLst>
            <c:ext xmlns:c16="http://schemas.microsoft.com/office/drawing/2014/chart" uri="{C3380CC4-5D6E-409C-BE32-E72D297353CC}">
              <c16:uniqueId val="{00000000-4259-456B-8A2B-05393729B65A}"/>
            </c:ext>
          </c:extLst>
        </c:ser>
        <c:ser>
          <c:idx val="1"/>
          <c:order val="1"/>
          <c:tx>
            <c:v>22q los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0"/>
              <c:pt idx="0">
                <c:v>0</c:v>
              </c:pt>
              <c:pt idx="1">
                <c:v>1</c:v>
              </c:pt>
              <c:pt idx="2">
                <c:v>2</c:v>
              </c:pt>
              <c:pt idx="3">
                <c:v>3</c:v>
              </c:pt>
              <c:pt idx="4">
                <c:v>4</c:v>
              </c:pt>
              <c:pt idx="5">
                <c:v>5</c:v>
              </c:pt>
              <c:pt idx="6">
                <c:v>6</c:v>
              </c:pt>
              <c:pt idx="7">
                <c:v>7</c:v>
              </c:pt>
              <c:pt idx="8">
                <c:v>8</c:v>
              </c:pt>
              <c:pt idx="9">
                <c:v>9</c:v>
              </c:pt>
            </c:numLit>
          </c:cat>
          <c:val>
            <c:numLit>
              <c:formatCode>General</c:formatCode>
              <c:ptCount val="10"/>
              <c:pt idx="0">
                <c:v>121</c:v>
              </c:pt>
              <c:pt idx="1">
                <c:v>74</c:v>
              </c:pt>
              <c:pt idx="2">
                <c:v>94</c:v>
              </c:pt>
              <c:pt idx="3">
                <c:v>74</c:v>
              </c:pt>
              <c:pt idx="4">
                <c:v>48</c:v>
              </c:pt>
              <c:pt idx="5">
                <c:v>104</c:v>
              </c:pt>
              <c:pt idx="6">
                <c:v>52</c:v>
              </c:pt>
              <c:pt idx="7">
                <c:v>15</c:v>
              </c:pt>
              <c:pt idx="8">
                <c:v>15</c:v>
              </c:pt>
              <c:pt idx="9">
                <c:v>3</c:v>
              </c:pt>
            </c:numLit>
          </c:val>
          <c:extLst>
            <c:ext xmlns:c16="http://schemas.microsoft.com/office/drawing/2014/chart" uri="{C3380CC4-5D6E-409C-BE32-E72D297353CC}">
              <c16:uniqueId val="{00000001-4259-456B-8A2B-05393729B6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1577409456"/>
        <c:axId val="1577409936"/>
      </c:barChart>
      <c:catAx>
        <c:axId val="1577409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7409936"/>
        <c:crosses val="autoZero"/>
        <c:auto val="1"/>
        <c:lblAlgn val="ctr"/>
        <c:lblOffset val="100"/>
        <c:noMultiLvlLbl val="0"/>
      </c:catAx>
      <c:valAx>
        <c:axId val="1577409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7409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v>22q intact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0"/>
              <c:pt idx="0">
                <c:v>0</c:v>
              </c:pt>
              <c:pt idx="1">
                <c:v>1</c:v>
              </c:pt>
              <c:pt idx="2">
                <c:v>2</c:v>
              </c:pt>
              <c:pt idx="3">
                <c:v>3</c:v>
              </c:pt>
              <c:pt idx="4">
                <c:v>4</c:v>
              </c:pt>
              <c:pt idx="5">
                <c:v>5</c:v>
              </c:pt>
              <c:pt idx="6">
                <c:v>6</c:v>
              </c:pt>
              <c:pt idx="7">
                <c:v>7</c:v>
              </c:pt>
              <c:pt idx="8">
                <c:v>8</c:v>
              </c:pt>
              <c:pt idx="9">
                <c:v>9</c:v>
              </c:pt>
            </c:numLit>
          </c:cat>
          <c:val>
            <c:numLit>
              <c:formatCode>General</c:formatCode>
              <c:ptCount val="10"/>
              <c:pt idx="0">
                <c:v>186</c:v>
              </c:pt>
              <c:pt idx="1">
                <c:v>97</c:v>
              </c:pt>
              <c:pt idx="2">
                <c:v>56</c:v>
              </c:pt>
              <c:pt idx="3">
                <c:v>36</c:v>
              </c:pt>
              <c:pt idx="4">
                <c:v>9</c:v>
              </c:pt>
              <c:pt idx="5">
                <c:v>4</c:v>
              </c:pt>
              <c:pt idx="6">
                <c:v>2</c:v>
              </c:pt>
            </c:numLit>
          </c:val>
          <c:extLst>
            <c:ext xmlns:c16="http://schemas.microsoft.com/office/drawing/2014/chart" uri="{C3380CC4-5D6E-409C-BE32-E72D297353CC}">
              <c16:uniqueId val="{00000000-7BC6-428F-8344-15F43471138A}"/>
            </c:ext>
          </c:extLst>
        </c:ser>
        <c:ser>
          <c:idx val="1"/>
          <c:order val="1"/>
          <c:tx>
            <c:v>22q loss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Lit>
              <c:formatCode>General</c:formatCode>
              <c:ptCount val="10"/>
              <c:pt idx="0">
                <c:v>0</c:v>
              </c:pt>
              <c:pt idx="1">
                <c:v>1</c:v>
              </c:pt>
              <c:pt idx="2">
                <c:v>2</c:v>
              </c:pt>
              <c:pt idx="3">
                <c:v>3</c:v>
              </c:pt>
              <c:pt idx="4">
                <c:v>4</c:v>
              </c:pt>
              <c:pt idx="5">
                <c:v>5</c:v>
              </c:pt>
              <c:pt idx="6">
                <c:v>6</c:v>
              </c:pt>
              <c:pt idx="7">
                <c:v>7</c:v>
              </c:pt>
              <c:pt idx="8">
                <c:v>8</c:v>
              </c:pt>
              <c:pt idx="9">
                <c:v>9</c:v>
              </c:pt>
            </c:numLit>
          </c:cat>
          <c:val>
            <c:numLit>
              <c:formatCode>General</c:formatCode>
              <c:ptCount val="10"/>
              <c:pt idx="0">
                <c:v>121</c:v>
              </c:pt>
              <c:pt idx="1">
                <c:v>74</c:v>
              </c:pt>
              <c:pt idx="2">
                <c:v>94</c:v>
              </c:pt>
              <c:pt idx="3">
                <c:v>74</c:v>
              </c:pt>
              <c:pt idx="4">
                <c:v>48</c:v>
              </c:pt>
              <c:pt idx="5">
                <c:v>104</c:v>
              </c:pt>
              <c:pt idx="6">
                <c:v>52</c:v>
              </c:pt>
              <c:pt idx="7">
                <c:v>15</c:v>
              </c:pt>
              <c:pt idx="8">
                <c:v>15</c:v>
              </c:pt>
              <c:pt idx="9">
                <c:v>3</c:v>
              </c:pt>
            </c:numLit>
          </c:val>
          <c:extLst>
            <c:ext xmlns:c16="http://schemas.microsoft.com/office/drawing/2014/chart" uri="{C3380CC4-5D6E-409C-BE32-E72D297353CC}">
              <c16:uniqueId val="{00000001-7BC6-428F-8344-15F4347113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1577409456"/>
        <c:axId val="1577409936"/>
      </c:barChart>
      <c:catAx>
        <c:axId val="1577409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7409936"/>
        <c:crosses val="autoZero"/>
        <c:auto val="1"/>
        <c:lblAlgn val="ctr"/>
        <c:lblOffset val="100"/>
        <c:noMultiLvlLbl val="0"/>
      </c:catAx>
      <c:valAx>
        <c:axId val="1577409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7409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odel score and mitotic counts: relative frequency</a:t>
            </a:r>
          </a:p>
        </c:rich>
      </c:tx>
      <c:layout>
        <c:manualLayout>
          <c:xMode val="edge"/>
          <c:yMode val="edge"/>
          <c:x val="0.11021126424471066"/>
          <c:y val="3.668373528716507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7822726066453907E-2"/>
          <c:y val="0.13228177854812995"/>
          <c:w val="0.80594263178630476"/>
          <c:h val="0.78438888279097174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Meningioma Project Data Analysis v2.1.xlsx]PIVOT 4.1 Flat'!$C$540</c:f>
              <c:strCache>
                <c:ptCount val="1"/>
                <c:pt idx="0">
                  <c:v>0-3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C$544:$C$553</c:f>
              <c:numCache>
                <c:formatCode>0</c:formatCode>
                <c:ptCount val="10"/>
                <c:pt idx="0">
                  <c:v>157</c:v>
                </c:pt>
                <c:pt idx="1">
                  <c:v>63</c:v>
                </c:pt>
                <c:pt idx="2">
                  <c:v>78</c:v>
                </c:pt>
                <c:pt idx="3">
                  <c:v>38</c:v>
                </c:pt>
                <c:pt idx="4">
                  <c:v>24</c:v>
                </c:pt>
                <c:pt idx="5">
                  <c:v>26</c:v>
                </c:pt>
                <c:pt idx="6">
                  <c:v>7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BF-41CB-9052-571D0D3A7FDA}"/>
            </c:ext>
          </c:extLst>
        </c:ser>
        <c:ser>
          <c:idx val="1"/>
          <c:order val="1"/>
          <c:tx>
            <c:strRef>
              <c:f>'[Meningioma Project Data Analysis v2.1.xlsx]PIVOT 4.1 Flat'!$D$540</c:f>
              <c:strCache>
                <c:ptCount val="1"/>
                <c:pt idx="0">
                  <c:v>4-7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D$544:$D$553</c:f>
              <c:numCache>
                <c:formatCode>0</c:formatCode>
                <c:ptCount val="10"/>
                <c:pt idx="1">
                  <c:v>98</c:v>
                </c:pt>
                <c:pt idx="2">
                  <c:v>1</c:v>
                </c:pt>
                <c:pt idx="3">
                  <c:v>46</c:v>
                </c:pt>
                <c:pt idx="4">
                  <c:v>5</c:v>
                </c:pt>
                <c:pt idx="5">
                  <c:v>51</c:v>
                </c:pt>
                <c:pt idx="6">
                  <c:v>28</c:v>
                </c:pt>
                <c:pt idx="7">
                  <c:v>3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BF-41CB-9052-571D0D3A7FDA}"/>
            </c:ext>
          </c:extLst>
        </c:ser>
        <c:ser>
          <c:idx val="2"/>
          <c:order val="2"/>
          <c:tx>
            <c:strRef>
              <c:f>'[Meningioma Project Data Analysis v2.1.xlsx]PIVOT 4.1 Flat'!$E$540</c:f>
              <c:strCache>
                <c:ptCount val="1"/>
                <c:pt idx="0">
                  <c:v>8-11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E$544:$E$553</c:f>
              <c:numCache>
                <c:formatCode>0</c:formatCode>
                <c:ptCount val="10"/>
                <c:pt idx="1">
                  <c:v>5</c:v>
                </c:pt>
                <c:pt idx="3">
                  <c:v>9</c:v>
                </c:pt>
                <c:pt idx="4">
                  <c:v>2</c:v>
                </c:pt>
                <c:pt idx="5">
                  <c:v>9</c:v>
                </c:pt>
                <c:pt idx="6">
                  <c:v>8</c:v>
                </c:pt>
                <c:pt idx="7">
                  <c:v>3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BF-41CB-9052-571D0D3A7FDA}"/>
            </c:ext>
          </c:extLst>
        </c:ser>
        <c:ser>
          <c:idx val="3"/>
          <c:order val="3"/>
          <c:tx>
            <c:strRef>
              <c:f>'[Meningioma Project Data Analysis v2.1.xlsx]PIVOT 4.1 Flat'!$F$540</c:f>
              <c:strCache>
                <c:ptCount val="1"/>
                <c:pt idx="0">
                  <c:v>12-15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F$544:$F$553</c:f>
              <c:numCache>
                <c:formatCode>General</c:formatCode>
                <c:ptCount val="10"/>
                <c:pt idx="3" formatCode="0">
                  <c:v>2</c:v>
                </c:pt>
                <c:pt idx="5" formatCode="0">
                  <c:v>2</c:v>
                </c:pt>
                <c:pt idx="6" formatCode="0">
                  <c:v>5</c:v>
                </c:pt>
                <c:pt idx="7" formatCode="0">
                  <c:v>3</c:v>
                </c:pt>
                <c:pt idx="8" formatCode="0">
                  <c:v>1</c:v>
                </c:pt>
                <c:pt idx="9" formatCode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EBF-41CB-9052-571D0D3A7FDA}"/>
            </c:ext>
          </c:extLst>
        </c:ser>
        <c:ser>
          <c:idx val="4"/>
          <c:order val="4"/>
          <c:tx>
            <c:strRef>
              <c:f>'[Meningioma Project Data Analysis v2.1.xlsx]PIVOT 4.1 Flat'!$G$540</c:f>
              <c:strCache>
                <c:ptCount val="1"/>
                <c:pt idx="0">
                  <c:v>16-19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G$544:$G$553</c:f>
              <c:numCache>
                <c:formatCode>General</c:formatCode>
                <c:ptCount val="10"/>
                <c:pt idx="3" formatCode="0">
                  <c:v>1</c:v>
                </c:pt>
                <c:pt idx="5" formatCode="0">
                  <c:v>5</c:v>
                </c:pt>
                <c:pt idx="6" formatCode="0">
                  <c:v>2</c:v>
                </c:pt>
                <c:pt idx="8" formatCode="0">
                  <c:v>4</c:v>
                </c:pt>
                <c:pt idx="9" formatCode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BF-41CB-9052-571D0D3A7FDA}"/>
            </c:ext>
          </c:extLst>
        </c:ser>
        <c:ser>
          <c:idx val="5"/>
          <c:order val="5"/>
          <c:tx>
            <c:strRef>
              <c:f>'[Meningioma Project Data Analysis v2.1.xlsx]PIVOT 4.1 Flat'!$H$540</c:f>
              <c:strCache>
                <c:ptCount val="1"/>
                <c:pt idx="0">
                  <c:v>20-30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H$544:$H$553</c:f>
              <c:numCache>
                <c:formatCode>General</c:formatCode>
                <c:ptCount val="10"/>
                <c:pt idx="4" formatCode="0">
                  <c:v>2</c:v>
                </c:pt>
                <c:pt idx="5" formatCode="0">
                  <c:v>1</c:v>
                </c:pt>
                <c:pt idx="6" formatCode="0">
                  <c:v>4</c:v>
                </c:pt>
                <c:pt idx="7" formatCode="0">
                  <c:v>5</c:v>
                </c:pt>
                <c:pt idx="8" formatCode="0">
                  <c:v>5</c:v>
                </c:pt>
                <c:pt idx="9" formatCode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EBF-41CB-9052-571D0D3A7F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47908447"/>
        <c:axId val="1847910367"/>
        <c:extLst/>
      </c:barChart>
      <c:catAx>
        <c:axId val="1847908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47910367"/>
        <c:crosses val="autoZero"/>
        <c:auto val="0"/>
        <c:lblAlgn val="ctr"/>
        <c:lblOffset val="100"/>
        <c:noMultiLvlLbl val="0"/>
      </c:catAx>
      <c:valAx>
        <c:axId val="18479103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47908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odel score and mitotic counts: absolute frequency</a:t>
            </a:r>
          </a:p>
        </c:rich>
      </c:tx>
      <c:layout>
        <c:manualLayout>
          <c:xMode val="edge"/>
          <c:yMode val="edge"/>
          <c:x val="0.11060136265383801"/>
          <c:y val="3.91293664593933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69983093614858E-2"/>
          <c:y val="0.13482896824577051"/>
          <c:w val="0.80951150601586341"/>
          <c:h val="0.7843888827909717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Meningioma Project Data Analysis v2.1.xlsx]PIVOT 4.1 Flat'!$C$540</c:f>
              <c:strCache>
                <c:ptCount val="1"/>
                <c:pt idx="0">
                  <c:v>0-3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C$544:$C$553</c:f>
              <c:numCache>
                <c:formatCode>0</c:formatCode>
                <c:ptCount val="10"/>
                <c:pt idx="0">
                  <c:v>157</c:v>
                </c:pt>
                <c:pt idx="1">
                  <c:v>63</c:v>
                </c:pt>
                <c:pt idx="2">
                  <c:v>78</c:v>
                </c:pt>
                <c:pt idx="3">
                  <c:v>38</c:v>
                </c:pt>
                <c:pt idx="4">
                  <c:v>24</c:v>
                </c:pt>
                <c:pt idx="5">
                  <c:v>26</c:v>
                </c:pt>
                <c:pt idx="6">
                  <c:v>7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FC-4600-B36B-546DF0EC3245}"/>
            </c:ext>
          </c:extLst>
        </c:ser>
        <c:ser>
          <c:idx val="1"/>
          <c:order val="1"/>
          <c:tx>
            <c:strRef>
              <c:f>'[Meningioma Project Data Analysis v2.1.xlsx]PIVOT 4.1 Flat'!$D$540</c:f>
              <c:strCache>
                <c:ptCount val="1"/>
                <c:pt idx="0">
                  <c:v>4-7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D$544:$D$553</c:f>
              <c:numCache>
                <c:formatCode>0</c:formatCode>
                <c:ptCount val="10"/>
                <c:pt idx="1">
                  <c:v>98</c:v>
                </c:pt>
                <c:pt idx="2">
                  <c:v>1</c:v>
                </c:pt>
                <c:pt idx="3">
                  <c:v>46</c:v>
                </c:pt>
                <c:pt idx="4">
                  <c:v>5</c:v>
                </c:pt>
                <c:pt idx="5">
                  <c:v>51</c:v>
                </c:pt>
                <c:pt idx="6">
                  <c:v>28</c:v>
                </c:pt>
                <c:pt idx="7">
                  <c:v>3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FC-4600-B36B-546DF0EC3245}"/>
            </c:ext>
          </c:extLst>
        </c:ser>
        <c:ser>
          <c:idx val="2"/>
          <c:order val="2"/>
          <c:tx>
            <c:strRef>
              <c:f>'[Meningioma Project Data Analysis v2.1.xlsx]PIVOT 4.1 Flat'!$E$540</c:f>
              <c:strCache>
                <c:ptCount val="1"/>
                <c:pt idx="0">
                  <c:v>8-11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E$544:$E$553</c:f>
              <c:numCache>
                <c:formatCode>0</c:formatCode>
                <c:ptCount val="10"/>
                <c:pt idx="1">
                  <c:v>5</c:v>
                </c:pt>
                <c:pt idx="3">
                  <c:v>9</c:v>
                </c:pt>
                <c:pt idx="4">
                  <c:v>2</c:v>
                </c:pt>
                <c:pt idx="5">
                  <c:v>9</c:v>
                </c:pt>
                <c:pt idx="6">
                  <c:v>8</c:v>
                </c:pt>
                <c:pt idx="7">
                  <c:v>3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3FC-4600-B36B-546DF0EC3245}"/>
            </c:ext>
          </c:extLst>
        </c:ser>
        <c:ser>
          <c:idx val="3"/>
          <c:order val="3"/>
          <c:tx>
            <c:strRef>
              <c:f>'[Meningioma Project Data Analysis v2.1.xlsx]PIVOT 4.1 Flat'!$F$540</c:f>
              <c:strCache>
                <c:ptCount val="1"/>
                <c:pt idx="0">
                  <c:v>12-15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F$544:$F$553</c:f>
              <c:numCache>
                <c:formatCode>General</c:formatCode>
                <c:ptCount val="10"/>
                <c:pt idx="3" formatCode="0">
                  <c:v>2</c:v>
                </c:pt>
                <c:pt idx="5" formatCode="0">
                  <c:v>2</c:v>
                </c:pt>
                <c:pt idx="6" formatCode="0">
                  <c:v>5</c:v>
                </c:pt>
                <c:pt idx="7" formatCode="0">
                  <c:v>3</c:v>
                </c:pt>
                <c:pt idx="8" formatCode="0">
                  <c:v>1</c:v>
                </c:pt>
                <c:pt idx="9" formatCode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3FC-4600-B36B-546DF0EC3245}"/>
            </c:ext>
          </c:extLst>
        </c:ser>
        <c:ser>
          <c:idx val="4"/>
          <c:order val="4"/>
          <c:tx>
            <c:strRef>
              <c:f>'[Meningioma Project Data Analysis v2.1.xlsx]PIVOT 4.1 Flat'!$G$540</c:f>
              <c:strCache>
                <c:ptCount val="1"/>
                <c:pt idx="0">
                  <c:v>16-19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G$544:$G$553</c:f>
              <c:numCache>
                <c:formatCode>General</c:formatCode>
                <c:ptCount val="10"/>
                <c:pt idx="3" formatCode="0">
                  <c:v>1</c:v>
                </c:pt>
                <c:pt idx="5" formatCode="0">
                  <c:v>5</c:v>
                </c:pt>
                <c:pt idx="6" formatCode="0">
                  <c:v>2</c:v>
                </c:pt>
                <c:pt idx="8" formatCode="0">
                  <c:v>4</c:v>
                </c:pt>
                <c:pt idx="9" formatCode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3FC-4600-B36B-546DF0EC3245}"/>
            </c:ext>
          </c:extLst>
        </c:ser>
        <c:ser>
          <c:idx val="5"/>
          <c:order val="5"/>
          <c:tx>
            <c:strRef>
              <c:f>'[Meningioma Project Data Analysis v2.1.xlsx]PIVOT 4.1 Flat'!$H$540</c:f>
              <c:strCache>
                <c:ptCount val="1"/>
                <c:pt idx="0">
                  <c:v>20-30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 4.1 Flat'!$B$544:$B$553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 4.1 Flat'!$H$544:$H$553</c:f>
              <c:numCache>
                <c:formatCode>General</c:formatCode>
                <c:ptCount val="10"/>
                <c:pt idx="4" formatCode="0">
                  <c:v>2</c:v>
                </c:pt>
                <c:pt idx="5" formatCode="0">
                  <c:v>1</c:v>
                </c:pt>
                <c:pt idx="6" formatCode="0">
                  <c:v>4</c:v>
                </c:pt>
                <c:pt idx="7" formatCode="0">
                  <c:v>5</c:v>
                </c:pt>
                <c:pt idx="8" formatCode="0">
                  <c:v>5</c:v>
                </c:pt>
                <c:pt idx="9" formatCode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3FC-4600-B36B-546DF0EC32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47908447"/>
        <c:axId val="1847910367"/>
        <c:extLst/>
      </c:barChart>
      <c:catAx>
        <c:axId val="1847908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47910367"/>
        <c:crosses val="autoZero"/>
        <c:auto val="1"/>
        <c:lblAlgn val="ctr"/>
        <c:lblOffset val="100"/>
        <c:noMultiLvlLbl val="0"/>
      </c:catAx>
      <c:valAx>
        <c:axId val="18479103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47908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423054367461376E-2"/>
          <c:y val="0.11382973828985439"/>
          <c:w val="0.88708121503213067"/>
          <c:h val="0.80793671836058967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[Meningioma Project Data Analysis v2.1.xlsx]PIVOT4.0_MA'!$J$7</c:f>
              <c:strCache>
                <c:ptCount val="1"/>
                <c:pt idx="0">
                  <c:v>F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4.0_MA'!$I$8:$I$17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4.0_MA'!$J$8:$J$17</c:f>
              <c:numCache>
                <c:formatCode>General</c:formatCode>
                <c:ptCount val="10"/>
                <c:pt idx="0">
                  <c:v>240</c:v>
                </c:pt>
                <c:pt idx="1">
                  <c:v>128</c:v>
                </c:pt>
                <c:pt idx="2">
                  <c:v>99</c:v>
                </c:pt>
                <c:pt idx="3">
                  <c:v>69</c:v>
                </c:pt>
                <c:pt idx="4">
                  <c:v>34</c:v>
                </c:pt>
                <c:pt idx="5">
                  <c:v>54</c:v>
                </c:pt>
                <c:pt idx="6">
                  <c:v>27</c:v>
                </c:pt>
                <c:pt idx="7">
                  <c:v>6</c:v>
                </c:pt>
                <c:pt idx="8">
                  <c:v>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59-43B9-8CCC-AA75CFD096C5}"/>
            </c:ext>
          </c:extLst>
        </c:ser>
        <c:ser>
          <c:idx val="1"/>
          <c:order val="1"/>
          <c:tx>
            <c:strRef>
              <c:f>'[Meningioma Project Data Analysis v2.1.xlsx]PIVOT4.0_MA'!$K$7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numRef>
              <c:f>'[Meningioma Project Data Analysis v2.1.xlsx]PIVOT4.0_MA'!$I$8:$I$17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[Meningioma Project Data Analysis v2.1.xlsx]PIVOT4.0_MA'!$K$8:$K$17</c:f>
              <c:numCache>
                <c:formatCode>General</c:formatCode>
                <c:ptCount val="10"/>
                <c:pt idx="0">
                  <c:v>-67</c:v>
                </c:pt>
                <c:pt idx="1">
                  <c:v>-43</c:v>
                </c:pt>
                <c:pt idx="2">
                  <c:v>-51</c:v>
                </c:pt>
                <c:pt idx="3">
                  <c:v>-41</c:v>
                </c:pt>
                <c:pt idx="4">
                  <c:v>-23</c:v>
                </c:pt>
                <c:pt idx="5">
                  <c:v>-54</c:v>
                </c:pt>
                <c:pt idx="6">
                  <c:v>-27</c:v>
                </c:pt>
                <c:pt idx="7">
                  <c:v>-9</c:v>
                </c:pt>
                <c:pt idx="8">
                  <c:v>-10</c:v>
                </c:pt>
                <c:pt idx="9">
                  <c:v>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59-43B9-8CCC-AA75CFD096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7"/>
        <c:overlap val="100"/>
        <c:axId val="1508070784"/>
        <c:axId val="1508069344"/>
      </c:barChart>
      <c:catAx>
        <c:axId val="15080707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8069344"/>
        <c:crosses val="autoZero"/>
        <c:auto val="1"/>
        <c:lblAlgn val="ctr"/>
        <c:lblOffset val="3"/>
        <c:tickLblSkip val="1"/>
        <c:noMultiLvlLbl val="0"/>
      </c:catAx>
      <c:valAx>
        <c:axId val="1508069344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;\ 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8070784"/>
        <c:crossesAt val="1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678854253833266"/>
          <c:y val="0.30599630957725982"/>
          <c:w val="6.9357435810947679E-2"/>
          <c:h val="0.1928488648776826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Meningioma%20Project%20Data%20Analysis%20v2.1(1).xlsx]Sex-ModelScore!PivotTable4</c:name>
    <c:fmtId val="10"/>
  </c:pivotSource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ale: model score by age group</a:t>
            </a:r>
          </a:p>
        </c:rich>
      </c:tx>
      <c:layout>
        <c:manualLayout>
          <c:xMode val="edge"/>
          <c:yMode val="edge"/>
          <c:x val="0.29204566412157429"/>
          <c:y val="2.9925135322875717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ivotFmts>
      <c:pivotFmt>
        <c:idx val="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rgbClr val="FFFF99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2">
              <a:lumMod val="75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rgbClr val="FFFF99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9"/>
        <c:spPr>
          <a:solidFill>
            <a:schemeClr val="accent2">
              <a:lumMod val="75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4"/>
        <c:spPr>
          <a:solidFill>
            <a:srgbClr val="FFFF99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9"/>
        <c:spPr>
          <a:solidFill>
            <a:schemeClr val="accent2">
              <a:lumMod val="75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>
        <c:manualLayout>
          <c:layoutTarget val="inner"/>
          <c:xMode val="edge"/>
          <c:yMode val="edge"/>
          <c:x val="4.322711891891811E-2"/>
          <c:y val="6.1822341911184492E-2"/>
          <c:w val="0.90461598905289375"/>
          <c:h val="0.8347984835775800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ex-ModelScore'!$R$2:$R$3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A9DFBF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R$4:$R$13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6</c:v>
                </c:pt>
                <c:pt idx="3">
                  <c:v>15</c:v>
                </c:pt>
                <c:pt idx="4">
                  <c:v>20</c:v>
                </c:pt>
                <c:pt idx="5">
                  <c:v>6</c:v>
                </c:pt>
                <c:pt idx="6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06-4190-94FF-884909A4448A}"/>
            </c:ext>
          </c:extLst>
        </c:ser>
        <c:ser>
          <c:idx val="1"/>
          <c:order val="1"/>
          <c:tx>
            <c:strRef>
              <c:f>'Sex-ModelScore'!$S$2:$S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7DCEA0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S$4:$S$13</c:f>
              <c:numCache>
                <c:formatCode>General</c:formatCode>
                <c:ptCount val="9"/>
                <c:pt idx="1">
                  <c:v>2</c:v>
                </c:pt>
                <c:pt idx="2">
                  <c:v>5</c:v>
                </c:pt>
                <c:pt idx="3">
                  <c:v>9</c:v>
                </c:pt>
                <c:pt idx="4">
                  <c:v>9</c:v>
                </c:pt>
                <c:pt idx="5">
                  <c:v>10</c:v>
                </c:pt>
                <c:pt idx="6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06-4190-94FF-884909A4448A}"/>
            </c:ext>
          </c:extLst>
        </c:ser>
        <c:ser>
          <c:idx val="2"/>
          <c:order val="2"/>
          <c:tx>
            <c:strRef>
              <c:f>'Sex-ModelScore'!$T$2:$T$3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52BE80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T$4:$T$13</c:f>
              <c:numCache>
                <c:formatCode>General</c:formatCode>
                <c:ptCount val="9"/>
                <c:pt idx="1">
                  <c:v>5</c:v>
                </c:pt>
                <c:pt idx="2">
                  <c:v>3</c:v>
                </c:pt>
                <c:pt idx="3">
                  <c:v>8</c:v>
                </c:pt>
                <c:pt idx="4">
                  <c:v>9</c:v>
                </c:pt>
                <c:pt idx="5">
                  <c:v>8</c:v>
                </c:pt>
                <c:pt idx="6">
                  <c:v>6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406-4190-94FF-884909A4448A}"/>
            </c:ext>
          </c:extLst>
        </c:ser>
        <c:ser>
          <c:idx val="3"/>
          <c:order val="3"/>
          <c:tx>
            <c:strRef>
              <c:f>'Sex-ModelScore'!$U$2:$U$3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9E79F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U$4:$U$13</c:f>
              <c:numCache>
                <c:formatCode>General</c:formatCode>
                <c:ptCount val="9"/>
                <c:pt idx="0">
                  <c:v>1</c:v>
                </c:pt>
                <c:pt idx="2">
                  <c:v>5</c:v>
                </c:pt>
                <c:pt idx="3">
                  <c:v>5</c:v>
                </c:pt>
                <c:pt idx="4">
                  <c:v>10</c:v>
                </c:pt>
                <c:pt idx="5">
                  <c:v>13</c:v>
                </c:pt>
                <c:pt idx="6">
                  <c:v>4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406-4190-94FF-884909A4448A}"/>
            </c:ext>
          </c:extLst>
        </c:ser>
        <c:ser>
          <c:idx val="4"/>
          <c:order val="4"/>
          <c:tx>
            <c:strRef>
              <c:f>'Sex-ModelScore'!$V$2:$V$3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7DC6F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V$4:$V$13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4</c:v>
                </c:pt>
                <c:pt idx="6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406-4190-94FF-884909A4448A}"/>
            </c:ext>
          </c:extLst>
        </c:ser>
        <c:ser>
          <c:idx val="5"/>
          <c:order val="5"/>
          <c:tx>
            <c:strRef>
              <c:f>'Sex-ModelScore'!$W$2:$W$3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rgbClr val="F4D03F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W$4:$W$13</c:f>
              <c:numCache>
                <c:formatCode>General</c:formatCode>
                <c:ptCount val="9"/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7</c:v>
                </c:pt>
                <c:pt idx="5">
                  <c:v>20</c:v>
                </c:pt>
                <c:pt idx="6">
                  <c:v>12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406-4190-94FF-884909A4448A}"/>
            </c:ext>
          </c:extLst>
        </c:ser>
        <c:ser>
          <c:idx val="6"/>
          <c:order val="6"/>
          <c:tx>
            <c:strRef>
              <c:f>'Sex-ModelScore'!$X$2:$X$3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X$4:$X$13</c:f>
              <c:numCache>
                <c:formatCode>General</c:formatCode>
                <c:ptCount val="9"/>
                <c:pt idx="2">
                  <c:v>2</c:v>
                </c:pt>
                <c:pt idx="3">
                  <c:v>2</c:v>
                </c:pt>
                <c:pt idx="4">
                  <c:v>6</c:v>
                </c:pt>
                <c:pt idx="5">
                  <c:v>9</c:v>
                </c:pt>
                <c:pt idx="6">
                  <c:v>7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406-4190-94FF-884909A4448A}"/>
            </c:ext>
          </c:extLst>
        </c:ser>
        <c:ser>
          <c:idx val="7"/>
          <c:order val="7"/>
          <c:tx>
            <c:strRef>
              <c:f>'Sex-ModelScore'!$Y$2:$Y$3</c:f>
              <c:strCache>
                <c:ptCount val="1"/>
                <c:pt idx="0">
                  <c:v>7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Y$4:$Y$13</c:f>
              <c:numCache>
                <c:formatCode>General</c:formatCode>
                <c:ptCount val="9"/>
                <c:pt idx="3">
                  <c:v>1</c:v>
                </c:pt>
                <c:pt idx="4">
                  <c:v>3</c:v>
                </c:pt>
                <c:pt idx="5">
                  <c:v>2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406-4190-94FF-884909A4448A}"/>
            </c:ext>
          </c:extLst>
        </c:ser>
        <c:ser>
          <c:idx val="8"/>
          <c:order val="8"/>
          <c:tx>
            <c:strRef>
              <c:f>'Sex-ModelScore'!$Z$2:$Z$3</c:f>
              <c:strCache>
                <c:ptCount val="1"/>
                <c:pt idx="0">
                  <c:v>8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Z$4:$Z$13</c:f>
              <c:numCache>
                <c:formatCode>General</c:formatCode>
                <c:ptCount val="9"/>
                <c:pt idx="3">
                  <c:v>1</c:v>
                </c:pt>
                <c:pt idx="4">
                  <c:v>1</c:v>
                </c:pt>
                <c:pt idx="5">
                  <c:v>5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406-4190-94FF-884909A4448A}"/>
            </c:ext>
          </c:extLst>
        </c:ser>
        <c:ser>
          <c:idx val="9"/>
          <c:order val="9"/>
          <c:tx>
            <c:strRef>
              <c:f>'Sex-ModelScore'!$AA$2:$AA$3</c:f>
              <c:strCache>
                <c:ptCount val="1"/>
                <c:pt idx="0">
                  <c:v>9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A$4:$AA$13</c:f>
              <c:numCache>
                <c:formatCode>General</c:formatCode>
                <c:ptCount val="9"/>
                <c:pt idx="4">
                  <c:v>2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406-4190-94FF-884909A444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86516112"/>
        <c:axId val="1508070304"/>
      </c:barChart>
      <c:catAx>
        <c:axId val="2865161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Age group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8070304"/>
        <c:crosses val="autoZero"/>
        <c:auto val="1"/>
        <c:lblAlgn val="ctr"/>
        <c:lblOffset val="100"/>
        <c:noMultiLvlLbl val="0"/>
      </c:catAx>
      <c:valAx>
        <c:axId val="1508070304"/>
        <c:scaling>
          <c:orientation val="minMax"/>
          <c:max val="1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6516112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4.7739625564491836E-2"/>
          <c:y val="6.5809378301779173E-2"/>
          <c:w val="8.0970270369960531E-2"/>
          <c:h val="0.65915365119639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4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Meningioma Project Data Analysis v2.1.xlsx]Sex-ModelScore!PivotTable7</c:name>
    <c:fmtId val="-1"/>
  </c:pivotSource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Female: model score by age group</a:t>
            </a:r>
          </a:p>
        </c:rich>
      </c:tx>
      <c:layout>
        <c:manualLayout>
          <c:xMode val="edge"/>
          <c:yMode val="edge"/>
          <c:x val="0.27846067806757668"/>
          <c:y val="1.50263920236598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ivotFmts>
      <c:pivotFmt>
        <c:idx val="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8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9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0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1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2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3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4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5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6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>
        <c:manualLayout>
          <c:layoutTarget val="inner"/>
          <c:xMode val="edge"/>
          <c:yMode val="edge"/>
          <c:x val="4.2951646447154754E-2"/>
          <c:y val="7.0302838029485504E-2"/>
          <c:w val="0.90914287899339818"/>
          <c:h val="0.8337044747866367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ex-ModelScore'!$AE$2:$AE$3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A9DFBF"/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E$4:$AE$13</c:f>
              <c:numCache>
                <c:formatCode>General</c:formatCode>
                <c:ptCount val="9"/>
                <c:pt idx="0">
                  <c:v>1</c:v>
                </c:pt>
                <c:pt idx="1">
                  <c:v>6</c:v>
                </c:pt>
                <c:pt idx="2">
                  <c:v>28</c:v>
                </c:pt>
                <c:pt idx="3">
                  <c:v>49</c:v>
                </c:pt>
                <c:pt idx="4">
                  <c:v>55</c:v>
                </c:pt>
                <c:pt idx="5">
                  <c:v>51</c:v>
                </c:pt>
                <c:pt idx="6">
                  <c:v>25</c:v>
                </c:pt>
                <c:pt idx="7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BD-49C3-9D9B-B7102AB84FAD}"/>
            </c:ext>
          </c:extLst>
        </c:ser>
        <c:ser>
          <c:idx val="1"/>
          <c:order val="1"/>
          <c:tx>
            <c:strRef>
              <c:f>'Sex-ModelScore'!$AF$2:$AF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7DCEA0"/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F$4:$AF$13</c:f>
              <c:numCache>
                <c:formatCode>General</c:formatCode>
                <c:ptCount val="9"/>
                <c:pt idx="1">
                  <c:v>1</c:v>
                </c:pt>
                <c:pt idx="2">
                  <c:v>11</c:v>
                </c:pt>
                <c:pt idx="3">
                  <c:v>27</c:v>
                </c:pt>
                <c:pt idx="4">
                  <c:v>41</c:v>
                </c:pt>
                <c:pt idx="5">
                  <c:v>26</c:v>
                </c:pt>
                <c:pt idx="6">
                  <c:v>18</c:v>
                </c:pt>
                <c:pt idx="7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BD-49C3-9D9B-B7102AB84FAD}"/>
            </c:ext>
          </c:extLst>
        </c:ser>
        <c:ser>
          <c:idx val="2"/>
          <c:order val="2"/>
          <c:tx>
            <c:strRef>
              <c:f>'Sex-ModelScore'!$AG$2:$AG$3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52BE80"/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G$4:$AG$13</c:f>
              <c:numCache>
                <c:formatCode>General</c:formatCode>
                <c:ptCount val="9"/>
                <c:pt idx="0">
                  <c:v>1</c:v>
                </c:pt>
                <c:pt idx="1">
                  <c:v>7</c:v>
                </c:pt>
                <c:pt idx="2">
                  <c:v>11</c:v>
                </c:pt>
                <c:pt idx="3">
                  <c:v>26</c:v>
                </c:pt>
                <c:pt idx="4">
                  <c:v>15</c:v>
                </c:pt>
                <c:pt idx="5">
                  <c:v>17</c:v>
                </c:pt>
                <c:pt idx="6">
                  <c:v>8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ABD-49C3-9D9B-B7102AB84FAD}"/>
            </c:ext>
          </c:extLst>
        </c:ser>
        <c:ser>
          <c:idx val="3"/>
          <c:order val="3"/>
          <c:tx>
            <c:strRef>
              <c:f>'Sex-ModelScore'!$AH$2:$AH$3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9E79F"/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H$4:$AH$13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6</c:v>
                </c:pt>
                <c:pt idx="3">
                  <c:v>19</c:v>
                </c:pt>
                <c:pt idx="4">
                  <c:v>19</c:v>
                </c:pt>
                <c:pt idx="5">
                  <c:v>10</c:v>
                </c:pt>
                <c:pt idx="6">
                  <c:v>8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ABD-49C3-9D9B-B7102AB84FAD}"/>
            </c:ext>
          </c:extLst>
        </c:ser>
        <c:ser>
          <c:idx val="4"/>
          <c:order val="4"/>
          <c:tx>
            <c:strRef>
              <c:f>'Sex-ModelScore'!$AI$2:$AI$3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7DC6F"/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I$4:$AI$13</c:f>
              <c:numCache>
                <c:formatCode>General</c:formatCode>
                <c:ptCount val="9"/>
                <c:pt idx="1">
                  <c:v>1</c:v>
                </c:pt>
                <c:pt idx="3">
                  <c:v>7</c:v>
                </c:pt>
                <c:pt idx="5">
                  <c:v>10</c:v>
                </c:pt>
                <c:pt idx="6">
                  <c:v>4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ABD-49C3-9D9B-B7102AB84FAD}"/>
            </c:ext>
          </c:extLst>
        </c:ser>
        <c:ser>
          <c:idx val="5"/>
          <c:order val="5"/>
          <c:tx>
            <c:strRef>
              <c:f>'Sex-ModelScore'!$AJ$2:$AJ$3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rgbClr val="F4D03F"/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J$4:$AJ$13</c:f>
              <c:numCache>
                <c:formatCode>General</c:formatCode>
                <c:ptCount val="9"/>
                <c:pt idx="0">
                  <c:v>1</c:v>
                </c:pt>
                <c:pt idx="2">
                  <c:v>4</c:v>
                </c:pt>
                <c:pt idx="3">
                  <c:v>8</c:v>
                </c:pt>
                <c:pt idx="4">
                  <c:v>9</c:v>
                </c:pt>
                <c:pt idx="5">
                  <c:v>16</c:v>
                </c:pt>
                <c:pt idx="6">
                  <c:v>10</c:v>
                </c:pt>
                <c:pt idx="7">
                  <c:v>3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ABD-49C3-9D9B-B7102AB84FAD}"/>
            </c:ext>
          </c:extLst>
        </c:ser>
        <c:ser>
          <c:idx val="6"/>
          <c:order val="6"/>
          <c:tx>
            <c:strRef>
              <c:f>'Sex-ModelScore'!$AK$2:$AK$3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K$4:$AK$13</c:f>
              <c:numCache>
                <c:formatCode>General</c:formatCode>
                <c:ptCount val="9"/>
                <c:pt idx="2">
                  <c:v>1</c:v>
                </c:pt>
                <c:pt idx="3">
                  <c:v>3</c:v>
                </c:pt>
                <c:pt idx="4">
                  <c:v>1</c:v>
                </c:pt>
                <c:pt idx="5">
                  <c:v>12</c:v>
                </c:pt>
                <c:pt idx="6">
                  <c:v>9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ABD-49C3-9D9B-B7102AB84FAD}"/>
            </c:ext>
          </c:extLst>
        </c:ser>
        <c:ser>
          <c:idx val="7"/>
          <c:order val="7"/>
          <c:tx>
            <c:strRef>
              <c:f>'Sex-ModelScore'!$AL$2:$AL$3</c:f>
              <c:strCache>
                <c:ptCount val="1"/>
                <c:pt idx="0">
                  <c:v>7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L$4:$AL$13</c:f>
              <c:numCache>
                <c:formatCode>General</c:formatCode>
                <c:ptCount val="9"/>
                <c:pt idx="1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ABD-49C3-9D9B-B7102AB84FAD}"/>
            </c:ext>
          </c:extLst>
        </c:ser>
        <c:ser>
          <c:idx val="8"/>
          <c:order val="8"/>
          <c:tx>
            <c:strRef>
              <c:f>'Sex-ModelScore'!$AM$2:$AM$3</c:f>
              <c:strCache>
                <c:ptCount val="1"/>
                <c:pt idx="0">
                  <c:v>8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M$4:$AM$13</c:f>
              <c:numCache>
                <c:formatCode>General</c:formatCode>
                <c:ptCount val="9"/>
                <c:pt idx="4">
                  <c:v>2</c:v>
                </c:pt>
                <c:pt idx="5">
                  <c:v>2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ABD-49C3-9D9B-B7102AB84F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038304"/>
        <c:axId val="12039264"/>
      </c:barChart>
      <c:catAx>
        <c:axId val="120383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Age group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9264"/>
        <c:crosses val="autoZero"/>
        <c:auto val="1"/>
        <c:lblAlgn val="ctr"/>
        <c:lblOffset val="100"/>
        <c:noMultiLvlLbl val="0"/>
      </c:catAx>
      <c:valAx>
        <c:axId val="12039264"/>
        <c:scaling>
          <c:orientation val="minMax"/>
          <c:max val="1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8304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4.6819452901555737E-2"/>
          <c:y val="6.8100791831700633E-2"/>
          <c:w val="7.3904565918485016E-2"/>
          <c:h val="0.6549727418882329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4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Meningioma%20Project%20Data%20Analysis%20v2.1(1).xlsx]Sex-ModelScore!PivotTable4</c:name>
    <c:fmtId val="10"/>
  </c:pivotSource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ale: model score by age group</a:t>
            </a:r>
          </a:p>
        </c:rich>
      </c:tx>
      <c:layout>
        <c:manualLayout>
          <c:xMode val="edge"/>
          <c:yMode val="edge"/>
          <c:x val="0.29204566412157429"/>
          <c:y val="2.9925135322875717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ivotFmts>
      <c:pivotFmt>
        <c:idx val="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rgbClr val="FFFF99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2">
              <a:lumMod val="75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rgbClr val="FFFF99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9"/>
        <c:spPr>
          <a:solidFill>
            <a:schemeClr val="accent2">
              <a:lumMod val="75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4"/>
        <c:spPr>
          <a:solidFill>
            <a:srgbClr val="FFFF99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9"/>
        <c:spPr>
          <a:solidFill>
            <a:schemeClr val="accent2">
              <a:lumMod val="75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>
        <c:manualLayout>
          <c:layoutTarget val="inner"/>
          <c:xMode val="edge"/>
          <c:yMode val="edge"/>
          <c:x val="0.14502877060971561"/>
          <c:y val="6.1822341911184492E-2"/>
          <c:w val="0.8185906089779057"/>
          <c:h val="0.83479848357758002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Sex-ModelScore'!$R$2:$R$3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A9DFB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R$4:$R$13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6</c:v>
                </c:pt>
                <c:pt idx="3">
                  <c:v>15</c:v>
                </c:pt>
                <c:pt idx="4">
                  <c:v>20</c:v>
                </c:pt>
                <c:pt idx="5">
                  <c:v>6</c:v>
                </c:pt>
                <c:pt idx="6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06-4190-94FF-884909A4448A}"/>
            </c:ext>
          </c:extLst>
        </c:ser>
        <c:ser>
          <c:idx val="1"/>
          <c:order val="1"/>
          <c:tx>
            <c:strRef>
              <c:f>'Sex-ModelScore'!$S$2:$S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7DCEA0"/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S$4:$S$13</c:f>
              <c:numCache>
                <c:formatCode>General</c:formatCode>
                <c:ptCount val="9"/>
                <c:pt idx="1">
                  <c:v>2</c:v>
                </c:pt>
                <c:pt idx="2">
                  <c:v>5</c:v>
                </c:pt>
                <c:pt idx="3">
                  <c:v>9</c:v>
                </c:pt>
                <c:pt idx="4">
                  <c:v>9</c:v>
                </c:pt>
                <c:pt idx="5">
                  <c:v>10</c:v>
                </c:pt>
                <c:pt idx="6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06-4190-94FF-884909A4448A}"/>
            </c:ext>
          </c:extLst>
        </c:ser>
        <c:ser>
          <c:idx val="2"/>
          <c:order val="2"/>
          <c:tx>
            <c:strRef>
              <c:f>'Sex-ModelScore'!$T$2:$T$3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52BE8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T$4:$T$13</c:f>
              <c:numCache>
                <c:formatCode>General</c:formatCode>
                <c:ptCount val="9"/>
                <c:pt idx="1">
                  <c:v>5</c:v>
                </c:pt>
                <c:pt idx="2">
                  <c:v>3</c:v>
                </c:pt>
                <c:pt idx="3">
                  <c:v>8</c:v>
                </c:pt>
                <c:pt idx="4">
                  <c:v>9</c:v>
                </c:pt>
                <c:pt idx="5">
                  <c:v>8</c:v>
                </c:pt>
                <c:pt idx="6">
                  <c:v>6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406-4190-94FF-884909A4448A}"/>
            </c:ext>
          </c:extLst>
        </c:ser>
        <c:ser>
          <c:idx val="3"/>
          <c:order val="3"/>
          <c:tx>
            <c:strRef>
              <c:f>'Sex-ModelScore'!$U$2:$U$3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9E79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U$4:$U$13</c:f>
              <c:numCache>
                <c:formatCode>General</c:formatCode>
                <c:ptCount val="9"/>
                <c:pt idx="0">
                  <c:v>1</c:v>
                </c:pt>
                <c:pt idx="2">
                  <c:v>5</c:v>
                </c:pt>
                <c:pt idx="3">
                  <c:v>5</c:v>
                </c:pt>
                <c:pt idx="4">
                  <c:v>10</c:v>
                </c:pt>
                <c:pt idx="5">
                  <c:v>13</c:v>
                </c:pt>
                <c:pt idx="6">
                  <c:v>4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406-4190-94FF-884909A4448A}"/>
            </c:ext>
          </c:extLst>
        </c:ser>
        <c:ser>
          <c:idx val="4"/>
          <c:order val="4"/>
          <c:tx>
            <c:strRef>
              <c:f>'Sex-ModelScore'!$V$2:$V$3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7DC6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V$4:$V$13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4</c:v>
                </c:pt>
                <c:pt idx="6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406-4190-94FF-884909A4448A}"/>
            </c:ext>
          </c:extLst>
        </c:ser>
        <c:ser>
          <c:idx val="5"/>
          <c:order val="5"/>
          <c:tx>
            <c:strRef>
              <c:f>'Sex-ModelScore'!$W$2:$W$3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rgbClr val="F4D03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W$4:$W$13</c:f>
              <c:numCache>
                <c:formatCode>General</c:formatCode>
                <c:ptCount val="9"/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7</c:v>
                </c:pt>
                <c:pt idx="5">
                  <c:v>20</c:v>
                </c:pt>
                <c:pt idx="6">
                  <c:v>12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406-4190-94FF-884909A4448A}"/>
            </c:ext>
          </c:extLst>
        </c:ser>
        <c:ser>
          <c:idx val="6"/>
          <c:order val="6"/>
          <c:tx>
            <c:strRef>
              <c:f>'Sex-ModelScore'!$X$2:$X$3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X$4:$X$13</c:f>
              <c:numCache>
                <c:formatCode>General</c:formatCode>
                <c:ptCount val="9"/>
                <c:pt idx="2">
                  <c:v>2</c:v>
                </c:pt>
                <c:pt idx="3">
                  <c:v>2</c:v>
                </c:pt>
                <c:pt idx="4">
                  <c:v>6</c:v>
                </c:pt>
                <c:pt idx="5">
                  <c:v>9</c:v>
                </c:pt>
                <c:pt idx="6">
                  <c:v>7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406-4190-94FF-884909A4448A}"/>
            </c:ext>
          </c:extLst>
        </c:ser>
        <c:ser>
          <c:idx val="7"/>
          <c:order val="7"/>
          <c:tx>
            <c:strRef>
              <c:f>'Sex-ModelScore'!$Y$2:$Y$3</c:f>
              <c:strCache>
                <c:ptCount val="1"/>
                <c:pt idx="0">
                  <c:v>7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Y$4:$Y$13</c:f>
              <c:numCache>
                <c:formatCode>General</c:formatCode>
                <c:ptCount val="9"/>
                <c:pt idx="3">
                  <c:v>1</c:v>
                </c:pt>
                <c:pt idx="4">
                  <c:v>3</c:v>
                </c:pt>
                <c:pt idx="5">
                  <c:v>2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406-4190-94FF-884909A4448A}"/>
            </c:ext>
          </c:extLst>
        </c:ser>
        <c:ser>
          <c:idx val="8"/>
          <c:order val="8"/>
          <c:tx>
            <c:strRef>
              <c:f>'Sex-ModelScore'!$Z$2:$Z$3</c:f>
              <c:strCache>
                <c:ptCount val="1"/>
                <c:pt idx="0">
                  <c:v>8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Z$4:$Z$13</c:f>
              <c:numCache>
                <c:formatCode>General</c:formatCode>
                <c:ptCount val="9"/>
                <c:pt idx="3">
                  <c:v>1</c:v>
                </c:pt>
                <c:pt idx="4">
                  <c:v>1</c:v>
                </c:pt>
                <c:pt idx="5">
                  <c:v>5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406-4190-94FF-884909A4448A}"/>
            </c:ext>
          </c:extLst>
        </c:ser>
        <c:ser>
          <c:idx val="9"/>
          <c:order val="9"/>
          <c:tx>
            <c:strRef>
              <c:f>'Sex-ModelScore'!$AA$2:$AA$3</c:f>
              <c:strCache>
                <c:ptCount val="1"/>
                <c:pt idx="0">
                  <c:v>9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Q$4:$Q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A$4:$AA$13</c:f>
              <c:numCache>
                <c:formatCode>General</c:formatCode>
                <c:ptCount val="9"/>
                <c:pt idx="4">
                  <c:v>2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406-4190-94FF-884909A444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86516112"/>
        <c:axId val="1508070304"/>
      </c:barChart>
      <c:catAx>
        <c:axId val="2865161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Age group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8070304"/>
        <c:crosses val="autoZero"/>
        <c:auto val="1"/>
        <c:lblAlgn val="ctr"/>
        <c:lblOffset val="100"/>
        <c:noMultiLvlLbl val="0"/>
      </c:catAx>
      <c:valAx>
        <c:axId val="15080703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6516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8.9520858692043563E-4"/>
          <c:y val="6.5809378301779201E-2"/>
          <c:w val="5.542178451551031E-2"/>
          <c:h val="0.577425514688764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4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Meningioma Project Data Analysis v2.1.xlsx]Sex-ModelScore!PivotTable7</c:name>
    <c:fmtId val="-1"/>
  </c:pivotSource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Female: model score by age group</a:t>
            </a:r>
          </a:p>
        </c:rich>
      </c:tx>
      <c:layout>
        <c:manualLayout>
          <c:xMode val="edge"/>
          <c:yMode val="edge"/>
          <c:x val="0.27846067806757668"/>
          <c:y val="1.50263920236598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ivotFmts>
      <c:pivotFmt>
        <c:idx val="0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8"/>
        <c:spPr>
          <a:solidFill>
            <a:schemeClr val="accent3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9"/>
        <c:spPr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0"/>
        <c:spPr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1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2"/>
        <c:spPr>
          <a:solidFill>
            <a:srgbClr val="FFFFCC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3"/>
        <c:spPr>
          <a:solidFill>
            <a:srgbClr val="FFFF66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4"/>
        <c:spPr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5"/>
        <c:spPr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6"/>
        <c:spPr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>
        <c:manualLayout>
          <c:layoutTarget val="inner"/>
          <c:xMode val="edge"/>
          <c:yMode val="edge"/>
          <c:x val="0.14966348784088077"/>
          <c:y val="7.0302838029485504E-2"/>
          <c:w val="0.8140044062152999"/>
          <c:h val="0.83370447478663678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Sex-ModelScore'!$AE$2:$AE$3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A9DFB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E$4:$AE$13</c:f>
              <c:numCache>
                <c:formatCode>General</c:formatCode>
                <c:ptCount val="9"/>
                <c:pt idx="0">
                  <c:v>1</c:v>
                </c:pt>
                <c:pt idx="1">
                  <c:v>6</c:v>
                </c:pt>
                <c:pt idx="2">
                  <c:v>28</c:v>
                </c:pt>
                <c:pt idx="3">
                  <c:v>49</c:v>
                </c:pt>
                <c:pt idx="4">
                  <c:v>55</c:v>
                </c:pt>
                <c:pt idx="5">
                  <c:v>51</c:v>
                </c:pt>
                <c:pt idx="6">
                  <c:v>25</c:v>
                </c:pt>
                <c:pt idx="7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BD-49C3-9D9B-B7102AB84FAD}"/>
            </c:ext>
          </c:extLst>
        </c:ser>
        <c:ser>
          <c:idx val="1"/>
          <c:order val="1"/>
          <c:tx>
            <c:strRef>
              <c:f>'Sex-ModelScore'!$AF$2:$AF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7DCEA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F$4:$AF$13</c:f>
              <c:numCache>
                <c:formatCode>General</c:formatCode>
                <c:ptCount val="9"/>
                <c:pt idx="1">
                  <c:v>1</c:v>
                </c:pt>
                <c:pt idx="2">
                  <c:v>11</c:v>
                </c:pt>
                <c:pt idx="3">
                  <c:v>27</c:v>
                </c:pt>
                <c:pt idx="4">
                  <c:v>41</c:v>
                </c:pt>
                <c:pt idx="5">
                  <c:v>26</c:v>
                </c:pt>
                <c:pt idx="6">
                  <c:v>18</c:v>
                </c:pt>
                <c:pt idx="7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BD-49C3-9D9B-B7102AB84FAD}"/>
            </c:ext>
          </c:extLst>
        </c:ser>
        <c:ser>
          <c:idx val="2"/>
          <c:order val="2"/>
          <c:tx>
            <c:strRef>
              <c:f>'Sex-ModelScore'!$AG$2:$AG$3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52BE8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G$4:$AG$13</c:f>
              <c:numCache>
                <c:formatCode>General</c:formatCode>
                <c:ptCount val="9"/>
                <c:pt idx="0">
                  <c:v>1</c:v>
                </c:pt>
                <c:pt idx="1">
                  <c:v>7</c:v>
                </c:pt>
                <c:pt idx="2">
                  <c:v>11</c:v>
                </c:pt>
                <c:pt idx="3">
                  <c:v>26</c:v>
                </c:pt>
                <c:pt idx="4">
                  <c:v>15</c:v>
                </c:pt>
                <c:pt idx="5">
                  <c:v>17</c:v>
                </c:pt>
                <c:pt idx="6">
                  <c:v>8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ABD-49C3-9D9B-B7102AB84FAD}"/>
            </c:ext>
          </c:extLst>
        </c:ser>
        <c:ser>
          <c:idx val="3"/>
          <c:order val="3"/>
          <c:tx>
            <c:strRef>
              <c:f>'Sex-ModelScore'!$AH$2:$AH$3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9E79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H$4:$AH$13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6</c:v>
                </c:pt>
                <c:pt idx="3">
                  <c:v>19</c:v>
                </c:pt>
                <c:pt idx="4">
                  <c:v>19</c:v>
                </c:pt>
                <c:pt idx="5">
                  <c:v>10</c:v>
                </c:pt>
                <c:pt idx="6">
                  <c:v>8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ABD-49C3-9D9B-B7102AB84FAD}"/>
            </c:ext>
          </c:extLst>
        </c:ser>
        <c:ser>
          <c:idx val="4"/>
          <c:order val="4"/>
          <c:tx>
            <c:strRef>
              <c:f>'Sex-ModelScore'!$AI$2:$AI$3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7DC6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I$4:$AI$13</c:f>
              <c:numCache>
                <c:formatCode>General</c:formatCode>
                <c:ptCount val="9"/>
                <c:pt idx="1">
                  <c:v>1</c:v>
                </c:pt>
                <c:pt idx="3">
                  <c:v>7</c:v>
                </c:pt>
                <c:pt idx="5">
                  <c:v>10</c:v>
                </c:pt>
                <c:pt idx="6">
                  <c:v>4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ABD-49C3-9D9B-B7102AB84FAD}"/>
            </c:ext>
          </c:extLst>
        </c:ser>
        <c:ser>
          <c:idx val="5"/>
          <c:order val="5"/>
          <c:tx>
            <c:strRef>
              <c:f>'Sex-ModelScore'!$AJ$2:$AJ$3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rgbClr val="F4D03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J$4:$AJ$13</c:f>
              <c:numCache>
                <c:formatCode>General</c:formatCode>
                <c:ptCount val="9"/>
                <c:pt idx="0">
                  <c:v>1</c:v>
                </c:pt>
                <c:pt idx="2">
                  <c:v>4</c:v>
                </c:pt>
                <c:pt idx="3">
                  <c:v>8</c:v>
                </c:pt>
                <c:pt idx="4">
                  <c:v>9</c:v>
                </c:pt>
                <c:pt idx="5">
                  <c:v>16</c:v>
                </c:pt>
                <c:pt idx="6">
                  <c:v>10</c:v>
                </c:pt>
                <c:pt idx="7">
                  <c:v>3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ABD-49C3-9D9B-B7102AB84FAD}"/>
            </c:ext>
          </c:extLst>
        </c:ser>
        <c:ser>
          <c:idx val="6"/>
          <c:order val="6"/>
          <c:tx>
            <c:strRef>
              <c:f>'Sex-ModelScore'!$AK$2:$AK$3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K$4:$AK$13</c:f>
              <c:numCache>
                <c:formatCode>General</c:formatCode>
                <c:ptCount val="9"/>
                <c:pt idx="2">
                  <c:v>1</c:v>
                </c:pt>
                <c:pt idx="3">
                  <c:v>3</c:v>
                </c:pt>
                <c:pt idx="4">
                  <c:v>1</c:v>
                </c:pt>
                <c:pt idx="5">
                  <c:v>12</c:v>
                </c:pt>
                <c:pt idx="6">
                  <c:v>9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ABD-49C3-9D9B-B7102AB84FAD}"/>
            </c:ext>
          </c:extLst>
        </c:ser>
        <c:ser>
          <c:idx val="7"/>
          <c:order val="7"/>
          <c:tx>
            <c:strRef>
              <c:f>'Sex-ModelScore'!$AL$2:$AL$3</c:f>
              <c:strCache>
                <c:ptCount val="1"/>
                <c:pt idx="0">
                  <c:v>7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3"/>
              <c:layout>
                <c:manualLayout>
                  <c:x val="1.8727889661762514E-2"/>
                  <c:y val="9.0158352141958935E-3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11E3-41AA-815C-D833F89876C4}"/>
                </c:ext>
              </c:extLst>
            </c:dLbl>
            <c:dLbl>
              <c:idx val="4"/>
              <c:layout>
                <c:manualLayout>
                  <c:x val="2.8091834492643773E-2"/>
                  <c:y val="0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1E3-41AA-815C-D833F89876C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L$4:$AL$13</c:f>
              <c:numCache>
                <c:formatCode>General</c:formatCode>
                <c:ptCount val="9"/>
                <c:pt idx="1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ABD-49C3-9D9B-B7102AB84FAD}"/>
            </c:ext>
          </c:extLst>
        </c:ser>
        <c:ser>
          <c:idx val="8"/>
          <c:order val="8"/>
          <c:tx>
            <c:strRef>
              <c:f>'Sex-ModelScore'!$AM$2:$AM$3</c:f>
              <c:strCache>
                <c:ptCount val="1"/>
                <c:pt idx="0">
                  <c:v>8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Sex-ModelScore'!$AD$4:$AD$13</c:f>
              <c:strCache>
                <c:ptCount val="9"/>
                <c:pt idx="0">
                  <c:v>under 20</c:v>
                </c:pt>
                <c:pt idx="1">
                  <c:v>20-29</c:v>
                </c:pt>
                <c:pt idx="2">
                  <c:v>30-39</c:v>
                </c:pt>
                <c:pt idx="3">
                  <c:v>40-49</c:v>
                </c:pt>
                <c:pt idx="4">
                  <c:v>50-59</c:v>
                </c:pt>
                <c:pt idx="5">
                  <c:v>60-69</c:v>
                </c:pt>
                <c:pt idx="6">
                  <c:v>70-79</c:v>
                </c:pt>
                <c:pt idx="7">
                  <c:v>80-89</c:v>
                </c:pt>
                <c:pt idx="8">
                  <c:v>90 and more</c:v>
                </c:pt>
              </c:strCache>
            </c:strRef>
          </c:cat>
          <c:val>
            <c:numRef>
              <c:f>'Sex-ModelScore'!$AM$4:$AM$13</c:f>
              <c:numCache>
                <c:formatCode>General</c:formatCode>
                <c:ptCount val="9"/>
                <c:pt idx="4">
                  <c:v>2</c:v>
                </c:pt>
                <c:pt idx="5">
                  <c:v>2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ABD-49C3-9D9B-B7102AB84F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038304"/>
        <c:axId val="12039264"/>
      </c:barChart>
      <c:catAx>
        <c:axId val="120383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Age group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9264"/>
        <c:crosses val="autoZero"/>
        <c:auto val="1"/>
        <c:lblAlgn val="ctr"/>
        <c:lblOffset val="100"/>
        <c:noMultiLvlLbl val="0"/>
      </c:catAx>
      <c:valAx>
        <c:axId val="12039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8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2.3408018780976588E-3"/>
          <c:y val="6.8100791831700633E-2"/>
          <c:w val="5.5392526244851671E-2"/>
          <c:h val="0.5218997240349861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4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933989943574314E-2"/>
          <c:y val="0.10159500379382799"/>
          <c:w val="0.90864379103700266"/>
          <c:h val="0.8165728382621464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Meningioma Project Data Analysis v2.1.xlsx]Chr22 Pivot'!$G$4</c:f>
              <c:strCache>
                <c:ptCount val="1"/>
                <c:pt idx="0">
                  <c:v>No loss (0-5%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Meningioma Project Data Analysis v2.1.xlsx]Chr22 Pivot'!$F$5:$F$8</c:f>
              <c:strCache>
                <c:ptCount val="4"/>
                <c:pt idx="0">
                  <c:v>Meningioma CNS WHO Grade 1</c:v>
                </c:pt>
                <c:pt idx="1">
                  <c:v>Meningioma CNS WHO Grade 2</c:v>
                </c:pt>
                <c:pt idx="2">
                  <c:v>Meningioma CNS WHO Grade 3</c:v>
                </c:pt>
                <c:pt idx="3">
                  <c:v>Meningioma, Ungraded</c:v>
                </c:pt>
              </c:strCache>
            </c:strRef>
          </c:cat>
          <c:val>
            <c:numRef>
              <c:f>'[Meningioma Project Data Analysis v2.1.xlsx]Chr22 Pivot'!$G$5:$G$8</c:f>
              <c:numCache>
                <c:formatCode>General</c:formatCode>
                <c:ptCount val="4"/>
                <c:pt idx="0">
                  <c:v>220</c:v>
                </c:pt>
                <c:pt idx="1">
                  <c:v>139</c:v>
                </c:pt>
                <c:pt idx="3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30-442B-8A52-F40A8E37517D}"/>
            </c:ext>
          </c:extLst>
        </c:ser>
        <c:ser>
          <c:idx val="1"/>
          <c:order val="1"/>
          <c:tx>
            <c:strRef>
              <c:f>'[Meningioma Project Data Analysis v2.1.xlsx]Chr22 Pivot'!$H$4</c:f>
              <c:strCache>
                <c:ptCount val="1"/>
                <c:pt idx="0">
                  <c:v>Loss (&gt;5-100%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2"/>
              <c:layout>
                <c:manualLayout>
                  <c:x val="-8.4739751143906916E-17"/>
                  <c:y val="-3.7142417153709206E-3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A30-442B-8A52-F40A8E37517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Meningioma Project Data Analysis v2.1.xlsx]Chr22 Pivot'!$F$5:$F$8</c:f>
              <c:strCache>
                <c:ptCount val="4"/>
                <c:pt idx="0">
                  <c:v>Meningioma CNS WHO Grade 1</c:v>
                </c:pt>
                <c:pt idx="1">
                  <c:v>Meningioma CNS WHO Grade 2</c:v>
                </c:pt>
                <c:pt idx="2">
                  <c:v>Meningioma CNS WHO Grade 3</c:v>
                </c:pt>
                <c:pt idx="3">
                  <c:v>Meningioma, Ungraded</c:v>
                </c:pt>
              </c:strCache>
            </c:strRef>
          </c:cat>
          <c:val>
            <c:numRef>
              <c:f>'[Meningioma Project Data Analysis v2.1.xlsx]Chr22 Pivot'!$H$5:$H$8</c:f>
              <c:numCache>
                <c:formatCode>General</c:formatCode>
                <c:ptCount val="4"/>
                <c:pt idx="0">
                  <c:v>235</c:v>
                </c:pt>
                <c:pt idx="1">
                  <c:v>303</c:v>
                </c:pt>
                <c:pt idx="2">
                  <c:v>27</c:v>
                </c:pt>
                <c:pt idx="3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A30-442B-8A52-F40A8E37517D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765872032"/>
        <c:axId val="1765871552"/>
      </c:barChart>
      <c:catAx>
        <c:axId val="1765872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65871552"/>
        <c:crosses val="autoZero"/>
        <c:auto val="1"/>
        <c:lblAlgn val="ctr"/>
        <c:lblOffset val="100"/>
        <c:noMultiLvlLbl val="0"/>
      </c:catAx>
      <c:valAx>
        <c:axId val="1765871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658720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288009720495723"/>
          <c:y val="0.17529793088633225"/>
          <c:w val="0.28399738854648876"/>
          <c:h val="0.238080068219777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1</cdr:x>
      <cdr:y>1</cdr:y>
    </cdr:to>
    <cdr:pic>
      <cdr:nvPicPr>
        <cdr:cNvPr id="2" name="chart">
          <a:extLst xmlns:a="http://schemas.openxmlformats.org/drawingml/2006/main">
            <a:ext uri="{FF2B5EF4-FFF2-40B4-BE49-F238E27FC236}">
              <a16:creationId xmlns:a16="http://schemas.microsoft.com/office/drawing/2014/main" id="{B9739E13-F560-4301-B0B1-79B5351F405D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0" y="0"/>
          <a:ext cx="6473081" cy="4526707"/>
        </a:xfrm>
        <a:prstGeom xmlns:a="http://schemas.openxmlformats.org/drawingml/2006/main" prst="rect">
          <a:avLst/>
        </a:prstGeom>
      </cdr:spPr>
    </cdr:pic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1FF8BC-11DD-4982-AD2E-93B6870AB84A}" type="datetimeFigureOut">
              <a:rPr lang="en-GB" smtClean="0"/>
              <a:t>06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559B52-5057-4701-BD28-5C00943ED7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2800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667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6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612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269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521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45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419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329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596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044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609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4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154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5758060-310D-0066-593D-709004A8C0AE}"/>
              </a:ext>
            </a:extLst>
          </p:cNvPr>
          <p:cNvSpPr txBox="1"/>
          <p:nvPr/>
        </p:nvSpPr>
        <p:spPr>
          <a:xfrm>
            <a:off x="422516" y="252248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Supplementary Figure 1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78E77197-7501-4333-8A07-82AE4F1E6A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3428860"/>
              </p:ext>
            </p:extLst>
          </p:nvPr>
        </p:nvGraphicFramePr>
        <p:xfrm>
          <a:off x="192459" y="901310"/>
          <a:ext cx="6473081" cy="4526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3BF21B93-E17F-6087-ADBC-DF8705BA3296}"/>
              </a:ext>
            </a:extLst>
          </p:cNvPr>
          <p:cNvSpPr txBox="1"/>
          <p:nvPr/>
        </p:nvSpPr>
        <p:spPr>
          <a:xfrm>
            <a:off x="422516" y="624311"/>
            <a:ext cx="780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/>
              <a:t>Referrals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3695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80F6F07-97BF-D847-0138-6C09106EECD1}"/>
              </a:ext>
            </a:extLst>
          </p:cNvPr>
          <p:cNvSpPr txBox="1"/>
          <p:nvPr/>
        </p:nvSpPr>
        <p:spPr>
          <a:xfrm>
            <a:off x="213131" y="525913"/>
            <a:ext cx="5808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Meningioma grade and allocation to MC, Score 0.3 &lt;0.9 </a:t>
            </a:r>
          </a:p>
        </p:txBody>
      </p:sp>
      <p:pic>
        <p:nvPicPr>
          <p:cNvPr id="7" name="Picture 6" descr="A diagram of different colored lines">
            <a:extLst>
              <a:ext uri="{FF2B5EF4-FFF2-40B4-BE49-F238E27FC236}">
                <a16:creationId xmlns:a16="http://schemas.microsoft.com/office/drawing/2014/main" id="{425D5A0A-CC14-C067-7B88-121E78894AB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37264"/>
            <a:ext cx="6858000" cy="51435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2C91D6E-40BD-D80A-D5B5-93CDC2BA73C5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686864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5AB0AF1-93CE-C1ED-0544-7772FBB90B92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  <p:pic>
        <p:nvPicPr>
          <p:cNvPr id="7" name="Picture 6" descr="A colorful lines in a row&#10;&#10;Description automatically generated with medium confidence">
            <a:extLst>
              <a:ext uri="{FF2B5EF4-FFF2-40B4-BE49-F238E27FC236}">
                <a16:creationId xmlns:a16="http://schemas.microsoft.com/office/drawing/2014/main" id="{31212D6D-780A-7635-8C24-81F9CCDBC26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1238"/>
          <a:stretch/>
        </p:blipFill>
        <p:spPr>
          <a:xfrm>
            <a:off x="581487" y="1155481"/>
            <a:ext cx="5695026" cy="4218404"/>
          </a:xfrm>
          <a:prstGeom prst="rect">
            <a:avLst/>
          </a:prstGeom>
        </p:spPr>
      </p:pic>
      <p:pic>
        <p:nvPicPr>
          <p:cNvPr id="9" name="Picture 8" descr="A white background with many colored lines&#10;&#10;Description automatically generated">
            <a:extLst>
              <a:ext uri="{FF2B5EF4-FFF2-40B4-BE49-F238E27FC236}">
                <a16:creationId xmlns:a16="http://schemas.microsoft.com/office/drawing/2014/main" id="{CDC3D750-2BA9-78CF-7D4A-8C219933C11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42"/>
          <a:stretch/>
        </p:blipFill>
        <p:spPr>
          <a:xfrm>
            <a:off x="581487" y="5578203"/>
            <a:ext cx="5695026" cy="417121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369445-73A2-77B0-2F70-541609C033BF}"/>
              </a:ext>
            </a:extLst>
          </p:cNvPr>
          <p:cNvSpPr txBox="1"/>
          <p:nvPr/>
        </p:nvSpPr>
        <p:spPr>
          <a:xfrm>
            <a:off x="850056" y="951163"/>
            <a:ext cx="5026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llocation of mitotic count of all meningiomas to model scor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597188C-7A3A-E486-A2E6-A27B692E5C7E}"/>
              </a:ext>
            </a:extLst>
          </p:cNvPr>
          <p:cNvSpPr txBox="1"/>
          <p:nvPr/>
        </p:nvSpPr>
        <p:spPr>
          <a:xfrm>
            <a:off x="850056" y="5510550"/>
            <a:ext cx="5366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llocation of mitotic count of grade 2 meningiomas to model scor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6696979-8106-0AFD-E1DD-E9E8DA52BFD2}"/>
              </a:ext>
            </a:extLst>
          </p:cNvPr>
          <p:cNvSpPr txBox="1"/>
          <p:nvPr/>
        </p:nvSpPr>
        <p:spPr>
          <a:xfrm>
            <a:off x="99617" y="951163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BE6FF71-2748-C235-2B1F-D32BA18D252A}"/>
              </a:ext>
            </a:extLst>
          </p:cNvPr>
          <p:cNvSpPr txBox="1"/>
          <p:nvPr/>
        </p:nvSpPr>
        <p:spPr>
          <a:xfrm>
            <a:off x="99617" y="551055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39703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95B86D1B-1FD1-4AAF-D1FF-EA751A0ED4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2980167"/>
              </p:ext>
            </p:extLst>
          </p:nvPr>
        </p:nvGraphicFramePr>
        <p:xfrm>
          <a:off x="1038888" y="3472583"/>
          <a:ext cx="5181927" cy="2987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6E90CBC3-1001-DDC8-5BED-54D1DC5B23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0680137"/>
              </p:ext>
            </p:extLst>
          </p:nvPr>
        </p:nvGraphicFramePr>
        <p:xfrm>
          <a:off x="1035014" y="434930"/>
          <a:ext cx="5185232" cy="29882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9C4D592-5B19-1652-F4E8-ED28ACBE693D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4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3FCDC15-5D78-B327-D1F2-8945A82FD4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8319" y="6459658"/>
            <a:ext cx="5181927" cy="328976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9F75602-C609-89DA-0164-18D0A138BF1A}"/>
              </a:ext>
            </a:extLst>
          </p:cNvPr>
          <p:cNvSpPr txBox="1"/>
          <p:nvPr/>
        </p:nvSpPr>
        <p:spPr>
          <a:xfrm>
            <a:off x="213131" y="804262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7AB8736-AE60-A1A8-99CD-F75DE3B01107}"/>
              </a:ext>
            </a:extLst>
          </p:cNvPr>
          <p:cNvSpPr txBox="1"/>
          <p:nvPr/>
        </p:nvSpPr>
        <p:spPr>
          <a:xfrm>
            <a:off x="213131" y="353449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2E22B7-72E1-23F0-9D07-75057B0FF5A8}"/>
              </a:ext>
            </a:extLst>
          </p:cNvPr>
          <p:cNvSpPr txBox="1"/>
          <p:nvPr/>
        </p:nvSpPr>
        <p:spPr>
          <a:xfrm>
            <a:off x="213131" y="685486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0809623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A9DECA4-25EC-5FD0-81D0-46AAD64411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5498612"/>
              </p:ext>
            </p:extLst>
          </p:nvPr>
        </p:nvGraphicFramePr>
        <p:xfrm>
          <a:off x="181811" y="4508500"/>
          <a:ext cx="6494377" cy="4806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D337010E-6911-4CDA-665A-96BD9C906D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3744" y="1265677"/>
            <a:ext cx="6035563" cy="27556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BD4A435-EA61-400B-561E-6DEE26508A63}"/>
              </a:ext>
            </a:extLst>
          </p:cNvPr>
          <p:cNvSpPr txBox="1"/>
          <p:nvPr/>
        </p:nvSpPr>
        <p:spPr>
          <a:xfrm>
            <a:off x="697704" y="774293"/>
            <a:ext cx="5794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istribution of patient sex and meningioma WHO Grad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015C88-B603-6CC0-EFE7-0C7CE7188CE6}"/>
              </a:ext>
            </a:extLst>
          </p:cNvPr>
          <p:cNvSpPr txBox="1"/>
          <p:nvPr/>
        </p:nvSpPr>
        <p:spPr>
          <a:xfrm>
            <a:off x="697704" y="4139168"/>
            <a:ext cx="524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Distribution of patient sex and model score (n=990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BAF955-6A66-6A79-8DD9-C47E1E50DD0B}"/>
              </a:ext>
            </a:extLst>
          </p:cNvPr>
          <p:cNvSpPr txBox="1"/>
          <p:nvPr/>
        </p:nvSpPr>
        <p:spPr>
          <a:xfrm>
            <a:off x="1534119" y="4902716"/>
            <a:ext cx="13837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/>
              <a:t>Number of sampl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9C532A-1C2F-17C9-6A59-F21D6FD9C056}"/>
              </a:ext>
            </a:extLst>
          </p:cNvPr>
          <p:cNvSpPr txBox="1"/>
          <p:nvPr/>
        </p:nvSpPr>
        <p:spPr>
          <a:xfrm>
            <a:off x="629682" y="8419547"/>
            <a:ext cx="9348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/>
              <a:t>Model sco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CEE427-7E6E-2BE8-FE77-DFE97D351ACA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5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034E265D-3052-D43C-01FF-E5CDEB0CE6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5956443"/>
              </p:ext>
            </p:extLst>
          </p:nvPr>
        </p:nvGraphicFramePr>
        <p:xfrm>
          <a:off x="5746750" y="5049388"/>
          <a:ext cx="571500" cy="35009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1500">
                  <a:extLst>
                    <a:ext uri="{9D8B030D-6E8A-4147-A177-3AD203B41FA5}">
                      <a16:colId xmlns:a16="http://schemas.microsoft.com/office/drawing/2014/main" val="1992280677"/>
                    </a:ext>
                  </a:extLst>
                </a:gridCol>
              </a:tblGrid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3.6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4725793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3.0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6791289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1.9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2760658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1.7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089571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1.5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2603159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1.0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2222427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1.0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1890499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0.7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9187464"/>
                  </a:ext>
                </a:extLst>
              </a:tr>
              <a:tr h="388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</a:rPr>
                        <a:t>0.5 :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3678817"/>
                  </a:ext>
                </a:extLst>
              </a:tr>
            </a:tbl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1B523A7E-D00F-F347-75E0-71F14EE50A06}"/>
              </a:ext>
            </a:extLst>
          </p:cNvPr>
          <p:cNvSpPr txBox="1"/>
          <p:nvPr/>
        </p:nvSpPr>
        <p:spPr>
          <a:xfrm>
            <a:off x="1316008" y="1169025"/>
            <a:ext cx="8121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.4 : 1</a:t>
            </a:r>
            <a:endParaRPr lang="en-GB" sz="140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F835240-4AD3-DB61-5426-E50C8F5B74C7}"/>
              </a:ext>
            </a:extLst>
          </p:cNvPr>
          <p:cNvSpPr txBox="1"/>
          <p:nvPr/>
        </p:nvSpPr>
        <p:spPr>
          <a:xfrm>
            <a:off x="2652975" y="1169025"/>
            <a:ext cx="8121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.6</a:t>
            </a:r>
            <a:r>
              <a:rPr lang="en-GB" sz="1400"/>
              <a:t> :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3B52A1-8EF3-4BC8-5260-D6F031277CF1}"/>
              </a:ext>
            </a:extLst>
          </p:cNvPr>
          <p:cNvSpPr txBox="1"/>
          <p:nvPr/>
        </p:nvSpPr>
        <p:spPr>
          <a:xfrm>
            <a:off x="3989942" y="1169025"/>
            <a:ext cx="8121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7</a:t>
            </a:r>
            <a:r>
              <a:rPr lang="en-GB" sz="1400"/>
              <a:t> : 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254DF28-7D76-F29C-DAB1-09168D677CB0}"/>
              </a:ext>
            </a:extLst>
          </p:cNvPr>
          <p:cNvSpPr txBox="1"/>
          <p:nvPr/>
        </p:nvSpPr>
        <p:spPr>
          <a:xfrm>
            <a:off x="5326908" y="1169025"/>
            <a:ext cx="8121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.9</a:t>
            </a:r>
            <a:r>
              <a:rPr lang="en-GB" sz="1400"/>
              <a:t> : 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674C8A7-ABF5-5703-29CC-A62B9FCAF43B}"/>
              </a:ext>
            </a:extLst>
          </p:cNvPr>
          <p:cNvSpPr txBox="1"/>
          <p:nvPr/>
        </p:nvSpPr>
        <p:spPr>
          <a:xfrm>
            <a:off x="5988384" y="1169025"/>
            <a:ext cx="5190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:M</a:t>
            </a:r>
            <a:endParaRPr lang="en-GB" sz="140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F066739-3EE3-EB3C-3E6D-E0F0DF25374F}"/>
              </a:ext>
            </a:extLst>
          </p:cNvPr>
          <p:cNvSpPr txBox="1"/>
          <p:nvPr/>
        </p:nvSpPr>
        <p:spPr>
          <a:xfrm>
            <a:off x="5772952" y="8555924"/>
            <a:ext cx="5190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:M</a:t>
            </a:r>
            <a:endParaRPr lang="en-GB" sz="14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F7A9BA-EEF5-701D-B580-5350A363A77C}"/>
              </a:ext>
            </a:extLst>
          </p:cNvPr>
          <p:cNvSpPr txBox="1"/>
          <p:nvPr/>
        </p:nvSpPr>
        <p:spPr>
          <a:xfrm>
            <a:off x="181811" y="774293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5AD1CA-E28B-AB89-31E2-5DEF09CEC73C}"/>
              </a:ext>
            </a:extLst>
          </p:cNvPr>
          <p:cNvSpPr txBox="1"/>
          <p:nvPr/>
        </p:nvSpPr>
        <p:spPr>
          <a:xfrm>
            <a:off x="181811" y="413916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018946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14E56F82-7DAE-085C-D484-3C6791D88618}"/>
              </a:ext>
            </a:extLst>
          </p:cNvPr>
          <p:cNvGraphicFramePr>
            <a:graphicFrameLocks/>
          </p:cNvGraphicFramePr>
          <p:nvPr/>
        </p:nvGraphicFramePr>
        <p:xfrm>
          <a:off x="721522" y="1146043"/>
          <a:ext cx="5422200" cy="42439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F9E7870-39C9-FB32-366C-A204148E803A}"/>
              </a:ext>
            </a:extLst>
          </p:cNvPr>
          <p:cNvGraphicFramePr>
            <a:graphicFrameLocks/>
          </p:cNvGraphicFramePr>
          <p:nvPr/>
        </p:nvGraphicFramePr>
        <p:xfrm>
          <a:off x="716468" y="5456744"/>
          <a:ext cx="5425064" cy="4225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5EC5840-1BED-184E-2DE9-996FCCD9988E}"/>
              </a:ext>
            </a:extLst>
          </p:cNvPr>
          <p:cNvSpPr txBox="1"/>
          <p:nvPr/>
        </p:nvSpPr>
        <p:spPr>
          <a:xfrm>
            <a:off x="697704" y="709934"/>
            <a:ext cx="5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Distribution of model scores by patient age grou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719480-8DDE-D832-5181-4750DB4B1957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26738477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14E56F82-7DAE-085C-D484-3C6791D886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5623080"/>
              </p:ext>
            </p:extLst>
          </p:nvPr>
        </p:nvGraphicFramePr>
        <p:xfrm>
          <a:off x="721522" y="1146043"/>
          <a:ext cx="5422200" cy="42439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F9E7870-39C9-FB32-366C-A204148E80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5247175"/>
              </p:ext>
            </p:extLst>
          </p:nvPr>
        </p:nvGraphicFramePr>
        <p:xfrm>
          <a:off x="716468" y="5456744"/>
          <a:ext cx="5425064" cy="4225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5EC5840-1BED-184E-2DE9-996FCCD9988E}"/>
              </a:ext>
            </a:extLst>
          </p:cNvPr>
          <p:cNvSpPr txBox="1"/>
          <p:nvPr/>
        </p:nvSpPr>
        <p:spPr>
          <a:xfrm>
            <a:off x="697704" y="709934"/>
            <a:ext cx="579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Distribution of model scores by patient age patient grou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719480-8DDE-D832-5181-4750DB4B1957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18813721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3985B12-AE91-FC47-58FE-EB3A01C0BD89}"/>
              </a:ext>
            </a:extLst>
          </p:cNvPr>
          <p:cNvSpPr txBox="1"/>
          <p:nvPr/>
        </p:nvSpPr>
        <p:spPr>
          <a:xfrm>
            <a:off x="1230223" y="557770"/>
            <a:ext cx="4397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Loss of Chromosome 22q and WHO Grad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5652A2-43C2-A324-28ED-94C40D19EDF4}"/>
              </a:ext>
            </a:extLst>
          </p:cNvPr>
          <p:cNvSpPr txBox="1"/>
          <p:nvPr/>
        </p:nvSpPr>
        <p:spPr>
          <a:xfrm>
            <a:off x="213131" y="156581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Supplementary Figure </a:t>
            </a:r>
            <a:r>
              <a:rPr lang="en-GB" dirty="0"/>
              <a:t>8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4E0F495-DC9A-AA5E-F327-CF1019A493B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3991757"/>
              </p:ext>
            </p:extLst>
          </p:nvPr>
        </p:nvGraphicFramePr>
        <p:xfrm>
          <a:off x="1393073" y="658171"/>
          <a:ext cx="4084546" cy="3446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D1488C8-2980-2252-B9DF-3105807C8F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1441905"/>
              </p:ext>
            </p:extLst>
          </p:nvPr>
        </p:nvGraphicFramePr>
        <p:xfrm>
          <a:off x="1230223" y="4688567"/>
          <a:ext cx="4246578" cy="2564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BE359304-BA6B-2DBE-1A3B-59BCF484A9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3720357"/>
              </p:ext>
            </p:extLst>
          </p:nvPr>
        </p:nvGraphicFramePr>
        <p:xfrm>
          <a:off x="1230223" y="7252847"/>
          <a:ext cx="4246578" cy="2564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698FC5E-E49B-181B-0349-34527AB6AC90}"/>
              </a:ext>
            </a:extLst>
          </p:cNvPr>
          <p:cNvSpPr txBox="1"/>
          <p:nvPr/>
        </p:nvSpPr>
        <p:spPr>
          <a:xfrm>
            <a:off x="1230223" y="4373025"/>
            <a:ext cx="4428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Loss of Chromosome 22q and model sco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9DE092-1F9A-947B-F5CF-8908817E628C}"/>
              </a:ext>
            </a:extLst>
          </p:cNvPr>
          <p:cNvSpPr txBox="1"/>
          <p:nvPr/>
        </p:nvSpPr>
        <p:spPr>
          <a:xfrm>
            <a:off x="391498" y="437302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C8CB4DD-91D3-1D28-3C63-1D5858FD62FF}"/>
              </a:ext>
            </a:extLst>
          </p:cNvPr>
          <p:cNvSpPr txBox="1"/>
          <p:nvPr/>
        </p:nvSpPr>
        <p:spPr>
          <a:xfrm>
            <a:off x="391498" y="5704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8BD82E-910E-D778-5CE5-54AC144E9F7D}"/>
              </a:ext>
            </a:extLst>
          </p:cNvPr>
          <p:cNvSpPr txBox="1"/>
          <p:nvPr/>
        </p:nvSpPr>
        <p:spPr>
          <a:xfrm>
            <a:off x="391498" y="711631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00757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2007 - 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 2007-2010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E43CAEB60B92743AFD0E77DF82B7AF4" ma:contentTypeVersion="17" ma:contentTypeDescription="Create a new document." ma:contentTypeScope="" ma:versionID="a2a5850d42dd0f22dfec4b4a6c970ac1">
  <xsd:schema xmlns:xsd="http://www.w3.org/2001/XMLSchema" xmlns:xs="http://www.w3.org/2001/XMLSchema" xmlns:p="http://schemas.microsoft.com/office/2006/metadata/properties" xmlns:ns1="http://schemas.microsoft.com/sharepoint/v3" xmlns:ns2="a701ccf6-b251-4660-a010-e21433e19d44" xmlns:ns3="d9391ab8-8b27-471c-93b6-0e180dcfd43e" targetNamespace="http://schemas.microsoft.com/office/2006/metadata/properties" ma:root="true" ma:fieldsID="54965d9b8bbcaf2318f7e13740cea35b" ns1:_="" ns2:_="" ns3:_="">
    <xsd:import namespace="http://schemas.microsoft.com/sharepoint/v3"/>
    <xsd:import namespace="a701ccf6-b251-4660-a010-e21433e19d44"/>
    <xsd:import namespace="d9391ab8-8b27-471c-93b6-0e180dcfd43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1:_ip_UnifiedCompliancePolicyProperties" minOccurs="0"/>
                <xsd:element ref="ns1:_ip_UnifiedCompliancePolicyUIAction" minOccurs="0"/>
                <xsd:element ref="ns2:lcf76f155ced4ddcb4097134ff3c332f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ObjectDetectorVersions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4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5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01ccf6-b251-4660-a010-e21433e19d4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2c8d5fda-b97d-42c6-97e2-f76465e161c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391ab8-8b27-471c-93b6-0e180dcfd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EA6905C-C6A5-45DC-8CC6-A9F85010A552}">
  <ds:schemaRefs>
    <ds:schemaRef ds:uri="a701ccf6-b251-4660-a010-e21433e19d44"/>
    <ds:schemaRef ds:uri="d9391ab8-8b27-471c-93b6-0e180dcfd43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515598CD-0B4D-4C42-AD7B-A423EF498860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8</Words>
  <Application>Microsoft Office PowerPoint</Application>
  <PresentationFormat>A4 Paper (210x297 mm)</PresentationFormat>
  <Paragraphs>7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Brandner, Sebastian</cp:lastModifiedBy>
  <cp:revision>1</cp:revision>
  <dcterms:created xsi:type="dcterms:W3CDTF">2024-08-25T15:48:44Z</dcterms:created>
  <dcterms:modified xsi:type="dcterms:W3CDTF">2025-04-06T14:55:49Z</dcterms:modified>
</cp:coreProperties>
</file>